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9" r:id="rId3"/>
    <p:sldId id="258" r:id="rId4"/>
    <p:sldId id="260" r:id="rId5"/>
    <p:sldId id="257" r:id="rId6"/>
    <p:sldId id="262" r:id="rId7"/>
    <p:sldId id="263" r:id="rId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370" autoAdjust="0"/>
  </p:normalViewPr>
  <p:slideViewPr>
    <p:cSldViewPr snapToGrid="0">
      <p:cViewPr>
        <p:scale>
          <a:sx n="75" d="100"/>
          <a:sy n="75" d="100"/>
        </p:scale>
        <p:origin x="2436" y="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ng JungWon" userId="f625509f4158e876" providerId="LiveId" clId="{F811C5DE-DCF1-42D4-9D75-9FD4660EC6D4}"/>
    <pc:docChg chg="undo redo custSel addSld delSld modSld">
      <pc:chgData name="Jung JungWon" userId="f625509f4158e876" providerId="LiveId" clId="{F811C5DE-DCF1-42D4-9D75-9FD4660EC6D4}" dt="2021-09-23T12:17:54.714" v="148" actId="2711"/>
      <pc:docMkLst>
        <pc:docMk/>
      </pc:docMkLst>
      <pc:sldChg chg="del">
        <pc:chgData name="Jung JungWon" userId="f625509f4158e876" providerId="LiveId" clId="{F811C5DE-DCF1-42D4-9D75-9FD4660EC6D4}" dt="2021-08-18T02:33:11.400" v="1" actId="47"/>
        <pc:sldMkLst>
          <pc:docMk/>
          <pc:sldMk cId="3891717433" sldId="256"/>
        </pc:sldMkLst>
      </pc:sldChg>
      <pc:sldChg chg="modSp mod">
        <pc:chgData name="Jung JungWon" userId="f625509f4158e876" providerId="LiveId" clId="{F811C5DE-DCF1-42D4-9D75-9FD4660EC6D4}" dt="2021-08-18T03:18:51.485" v="80" actId="5793"/>
        <pc:sldMkLst>
          <pc:docMk/>
          <pc:sldMk cId="4109716099" sldId="257"/>
        </pc:sldMkLst>
        <pc:spChg chg="mod">
          <ac:chgData name="Jung JungWon" userId="f625509f4158e876" providerId="LiveId" clId="{F811C5DE-DCF1-42D4-9D75-9FD4660EC6D4}" dt="2021-08-18T03:18:51.485" v="80" actId="5793"/>
          <ac:spMkLst>
            <pc:docMk/>
            <pc:sldMk cId="4109716099" sldId="257"/>
            <ac:spMk id="39" creationId="{3E2C92B3-62A8-4DFA-B285-1EE8B69B1F03}"/>
          </ac:spMkLst>
        </pc:spChg>
      </pc:sldChg>
      <pc:sldChg chg="modSp mod">
        <pc:chgData name="Jung JungWon" userId="f625509f4158e876" providerId="LiveId" clId="{F811C5DE-DCF1-42D4-9D75-9FD4660EC6D4}" dt="2021-08-18T03:18:11.090" v="76" actId="113"/>
        <pc:sldMkLst>
          <pc:docMk/>
          <pc:sldMk cId="2816437327" sldId="258"/>
        </pc:sldMkLst>
        <pc:spChg chg="mod">
          <ac:chgData name="Jung JungWon" userId="f625509f4158e876" providerId="LiveId" clId="{F811C5DE-DCF1-42D4-9D75-9FD4660EC6D4}" dt="2021-08-18T03:18:11.090" v="76" actId="113"/>
          <ac:spMkLst>
            <pc:docMk/>
            <pc:sldMk cId="2816437327" sldId="258"/>
            <ac:spMk id="2" creationId="{1420A141-ABCA-4C93-931B-9EC8469BEDDA}"/>
          </ac:spMkLst>
        </pc:spChg>
      </pc:sldChg>
      <pc:sldChg chg="modSp mod">
        <pc:chgData name="Jung JungWon" userId="f625509f4158e876" providerId="LiveId" clId="{F811C5DE-DCF1-42D4-9D75-9FD4660EC6D4}" dt="2021-08-18T03:17:47.994" v="74" actId="5793"/>
        <pc:sldMkLst>
          <pc:docMk/>
          <pc:sldMk cId="1720250174" sldId="259"/>
        </pc:sldMkLst>
        <pc:spChg chg="mod">
          <ac:chgData name="Jung JungWon" userId="f625509f4158e876" providerId="LiveId" clId="{F811C5DE-DCF1-42D4-9D75-9FD4660EC6D4}" dt="2021-08-18T03:17:47.994" v="74" actId="5793"/>
          <ac:spMkLst>
            <pc:docMk/>
            <pc:sldMk cId="1720250174" sldId="259"/>
            <ac:spMk id="4" creationId="{EF605B1E-46CB-4CDB-A271-95257C4FABF8}"/>
          </ac:spMkLst>
        </pc:spChg>
      </pc:sldChg>
      <pc:sldChg chg="modSp mod">
        <pc:chgData name="Jung JungWon" userId="f625509f4158e876" providerId="LiveId" clId="{F811C5DE-DCF1-42D4-9D75-9FD4660EC6D4}" dt="2021-08-18T03:18:24.147" v="78" actId="5793"/>
        <pc:sldMkLst>
          <pc:docMk/>
          <pc:sldMk cId="2470623386" sldId="260"/>
        </pc:sldMkLst>
        <pc:spChg chg="mod">
          <ac:chgData name="Jung JungWon" userId="f625509f4158e876" providerId="LiveId" clId="{F811C5DE-DCF1-42D4-9D75-9FD4660EC6D4}" dt="2021-08-18T03:18:24.147" v="78" actId="5793"/>
          <ac:spMkLst>
            <pc:docMk/>
            <pc:sldMk cId="2470623386" sldId="260"/>
            <ac:spMk id="5" creationId="{4F3B6EBE-286A-4297-9B07-A5283C62AF9F}"/>
          </ac:spMkLst>
        </pc:spChg>
      </pc:sldChg>
      <pc:sldChg chg="addSp delSp modSp add mod">
        <pc:chgData name="Jung JungWon" userId="f625509f4158e876" providerId="LiveId" clId="{F811C5DE-DCF1-42D4-9D75-9FD4660EC6D4}" dt="2021-09-23T12:17:54.714" v="148" actId="2711"/>
        <pc:sldMkLst>
          <pc:docMk/>
          <pc:sldMk cId="3832529134" sldId="261"/>
        </pc:sldMkLst>
        <pc:spChg chg="del mod">
          <ac:chgData name="Jung JungWon" userId="f625509f4158e876" providerId="LiveId" clId="{F811C5DE-DCF1-42D4-9D75-9FD4660EC6D4}" dt="2021-08-18T02:35:27.223" v="18" actId="478"/>
          <ac:spMkLst>
            <pc:docMk/>
            <pc:sldMk cId="3832529134" sldId="261"/>
            <ac:spMk id="2" creationId="{00000000-0000-0000-0000-000000000000}"/>
          </ac:spMkLst>
        </pc:spChg>
        <pc:spChg chg="mod">
          <ac:chgData name="Jung JungWon" userId="f625509f4158e876" providerId="LiveId" clId="{F811C5DE-DCF1-42D4-9D75-9FD4660EC6D4}" dt="2021-09-23T12:17:54.714" v="148" actId="2711"/>
          <ac:spMkLst>
            <pc:docMk/>
            <pc:sldMk cId="3832529134" sldId="261"/>
            <ac:spMk id="3" creationId="{00000000-0000-0000-0000-000000000000}"/>
          </ac:spMkLst>
        </pc:spChg>
        <pc:spChg chg="add mod">
          <ac:chgData name="Jung JungWon" userId="f625509f4158e876" providerId="LiveId" clId="{F811C5DE-DCF1-42D4-9D75-9FD4660EC6D4}" dt="2021-08-18T04:24:49.966" v="99" actId="1076"/>
          <ac:spMkLst>
            <pc:docMk/>
            <pc:sldMk cId="3832529134" sldId="261"/>
            <ac:spMk id="5" creationId="{6C413AB3-7CAC-49AF-A457-CB48059AD047}"/>
          </ac:spMkLst>
        </pc:spChg>
      </pc:sldChg>
      <pc:sldChg chg="modSp new del mod">
        <pc:chgData name="Jung JungWon" userId="f625509f4158e876" providerId="LiveId" clId="{F811C5DE-DCF1-42D4-9D75-9FD4660EC6D4}" dt="2021-08-18T02:38:25.214" v="40" actId="47"/>
        <pc:sldMkLst>
          <pc:docMk/>
          <pc:sldMk cId="339239402" sldId="262"/>
        </pc:sldMkLst>
        <pc:spChg chg="mod">
          <ac:chgData name="Jung JungWon" userId="f625509f4158e876" providerId="LiveId" clId="{F811C5DE-DCF1-42D4-9D75-9FD4660EC6D4}" dt="2021-08-18T02:38:19.555" v="39"/>
          <ac:spMkLst>
            <pc:docMk/>
            <pc:sldMk cId="339239402" sldId="262"/>
            <ac:spMk id="3" creationId="{AD64778B-CFC5-44B0-9695-F16D08DB1018}"/>
          </ac:spMkLst>
        </pc:spChg>
      </pc:sldChg>
      <pc:sldChg chg="addSp modSp new mod">
        <pc:chgData name="Jung JungWon" userId="f625509f4158e876" providerId="LiveId" clId="{F811C5DE-DCF1-42D4-9D75-9FD4660EC6D4}" dt="2021-09-23T12:16:17.298" v="142" actId="5793"/>
        <pc:sldMkLst>
          <pc:docMk/>
          <pc:sldMk cId="3712883874" sldId="262"/>
        </pc:sldMkLst>
        <pc:spChg chg="add mod">
          <ac:chgData name="Jung JungWon" userId="f625509f4158e876" providerId="LiveId" clId="{F811C5DE-DCF1-42D4-9D75-9FD4660EC6D4}" dt="2021-09-23T12:16:17.298" v="142" actId="5793"/>
          <ac:spMkLst>
            <pc:docMk/>
            <pc:sldMk cId="3712883874" sldId="262"/>
            <ac:spMk id="3" creationId="{03593DD6-F5F2-41AC-9447-7927DFD64D8B}"/>
          </ac:spMkLst>
        </pc:spChg>
        <pc:picChg chg="add mod modCrop">
          <ac:chgData name="Jung JungWon" userId="f625509f4158e876" providerId="LiveId" clId="{F811C5DE-DCF1-42D4-9D75-9FD4660EC6D4}" dt="2021-09-23T12:16:04.778" v="140" actId="1076"/>
          <ac:picMkLst>
            <pc:docMk/>
            <pc:sldMk cId="3712883874" sldId="262"/>
            <ac:picMk id="2" creationId="{D1DF021D-371D-4A65-8182-4F0EA872AD0B}"/>
          </ac:picMkLst>
        </pc:picChg>
      </pc:sldChg>
      <pc:sldChg chg="addSp modSp new mod">
        <pc:chgData name="Jung JungWon" userId="f625509f4158e876" providerId="LiveId" clId="{F811C5DE-DCF1-42D4-9D75-9FD4660EC6D4}" dt="2021-09-23T12:16:32.327" v="145" actId="20577"/>
        <pc:sldMkLst>
          <pc:docMk/>
          <pc:sldMk cId="3335655864" sldId="263"/>
        </pc:sldMkLst>
        <pc:spChg chg="add mod">
          <ac:chgData name="Jung JungWon" userId="f625509f4158e876" providerId="LiveId" clId="{F811C5DE-DCF1-42D4-9D75-9FD4660EC6D4}" dt="2021-09-23T12:16:32.327" v="145" actId="20577"/>
          <ac:spMkLst>
            <pc:docMk/>
            <pc:sldMk cId="3335655864" sldId="263"/>
            <ac:spMk id="3" creationId="{01F4642D-FB77-4939-9BC1-F4E5C3B5EA00}"/>
          </ac:spMkLst>
        </pc:spChg>
        <pc:picChg chg="add mod modCrop">
          <ac:chgData name="Jung JungWon" userId="f625509f4158e876" providerId="LiveId" clId="{F811C5DE-DCF1-42D4-9D75-9FD4660EC6D4}" dt="2021-09-23T12:15:30.592" v="135" actId="14100"/>
          <ac:picMkLst>
            <pc:docMk/>
            <pc:sldMk cId="3335655864" sldId="263"/>
            <ac:picMk id="2" creationId="{DF784B60-FF2D-412F-80A0-E7A274D07594}"/>
          </ac:picMkLst>
        </pc:picChg>
      </pc:sldChg>
      <pc:sldChg chg="new del">
        <pc:chgData name="Jung JungWon" userId="f625509f4158e876" providerId="LiveId" clId="{F811C5DE-DCF1-42D4-9D75-9FD4660EC6D4}" dt="2021-09-23T12:16:34.676" v="146" actId="47"/>
        <pc:sldMkLst>
          <pc:docMk/>
          <pc:sldMk cId="3389018459" sldId="264"/>
        </pc:sldMkLst>
      </pc:sldChg>
    </pc:docChg>
  </pc:docChgLst>
  <pc:docChgLst>
    <pc:chgData name="Jung JungWon" userId="f625509f4158e876" providerId="LiveId" clId="{9C6DD216-718E-4078-8C3D-912B2A6AB68C}"/>
    <pc:docChg chg="modSld">
      <pc:chgData name="Jung JungWon" userId="f625509f4158e876" providerId="LiveId" clId="{9C6DD216-718E-4078-8C3D-912B2A6AB68C}" dt="2021-07-05T04:35:44.968" v="9" actId="20577"/>
      <pc:docMkLst>
        <pc:docMk/>
      </pc:docMkLst>
      <pc:sldChg chg="modSp mod">
        <pc:chgData name="Jung JungWon" userId="f625509f4158e876" providerId="LiveId" clId="{9C6DD216-718E-4078-8C3D-912B2A6AB68C}" dt="2021-07-05T04:35:44.968" v="9" actId="20577"/>
        <pc:sldMkLst>
          <pc:docMk/>
          <pc:sldMk cId="4109716099" sldId="257"/>
        </pc:sldMkLst>
        <pc:spChg chg="mod">
          <ac:chgData name="Jung JungWon" userId="f625509f4158e876" providerId="LiveId" clId="{9C6DD216-718E-4078-8C3D-912B2A6AB68C}" dt="2021-07-05T04:35:44.968" v="9" actId="20577"/>
          <ac:spMkLst>
            <pc:docMk/>
            <pc:sldMk cId="4109716099" sldId="257"/>
            <ac:spMk id="39" creationId="{3E2C92B3-62A8-4DFA-B285-1EE8B69B1F03}"/>
          </ac:spMkLst>
        </pc:spChg>
      </pc:sldChg>
    </pc:docChg>
  </pc:docChgLst>
  <pc:docChgLst>
    <pc:chgData name="Jung JungWon" userId="f625509f4158e876" providerId="LiveId" clId="{377065F7-8CD6-48A1-AA44-DD06E29EE015}"/>
    <pc:docChg chg="undo redo custSel delSld modSld">
      <pc:chgData name="Jung JungWon" userId="f625509f4158e876" providerId="LiveId" clId="{377065F7-8CD6-48A1-AA44-DD06E29EE015}" dt="2021-06-16T13:49:42.852" v="206" actId="1076"/>
      <pc:docMkLst>
        <pc:docMk/>
      </pc:docMkLst>
      <pc:sldChg chg="modSp mod">
        <pc:chgData name="Jung JungWon" userId="f625509f4158e876" providerId="LiveId" clId="{377065F7-8CD6-48A1-AA44-DD06E29EE015}" dt="2021-06-16T13:49:42.852" v="206" actId="1076"/>
        <pc:sldMkLst>
          <pc:docMk/>
          <pc:sldMk cId="4109716099" sldId="257"/>
        </pc:sldMkLst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4" creationId="{431ECF90-251F-4FD3-A510-DAB62DD40388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5" creationId="{F717AECE-9C4A-4748-9743-3F1A57C76F6B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6" creationId="{88A97C23-2C1A-49E7-91D1-58B24CF1F522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7" creationId="{7F0736B8-FDD4-4694-933E-7D6D61554311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8" creationId="{B9BFB60F-3448-482A-9B20-2A1C2CB162FF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9" creationId="{E07760D5-408E-4227-BE1B-EA712D9CFAC5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0" creationId="{208A5B4A-59EC-438C-90E9-9FAA9CE3DC57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1" creationId="{A4627D94-BEE4-4ECB-99B0-37A584DD8BB7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2" creationId="{2D106D89-B20F-422C-A06F-356A606FABCD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3" creationId="{67F83757-72AF-4531-A975-4130C09F12E5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4" creationId="{D06BC161-7468-418C-AFF0-51BF8764F1C1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5" creationId="{48D716C6-BC80-4588-A9D5-8973AE642D7E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6" creationId="{E4644B77-A343-4B4B-80D5-6C1A40CF4342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17" creationId="{5A780FCD-1808-483F-AB0F-1145DC483626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1" creationId="{82DB7E56-219A-48C2-9E97-85ED5C40CBDD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2" creationId="{880D0333-B046-4322-A54F-EA2273E8466D}"/>
          </ac:spMkLst>
        </pc:spChg>
        <pc:spChg chg="mod">
          <ac:chgData name="Jung JungWon" userId="f625509f4158e876" providerId="LiveId" clId="{377065F7-8CD6-48A1-AA44-DD06E29EE015}" dt="2021-06-16T13:49:42.852" v="206" actId="1076"/>
          <ac:spMkLst>
            <pc:docMk/>
            <pc:sldMk cId="4109716099" sldId="257"/>
            <ac:spMk id="23" creationId="{AF15D00D-A64B-4192-A82C-7D7F6355E4EB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4" creationId="{544F6B19-39FB-471F-A4F6-51E876384ED3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5" creationId="{8BEBE95F-7FBB-424A-8CA8-B6B9224B3C45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6" creationId="{C1F56C82-1FAB-4ACB-AAB7-6975368D9D76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7" creationId="{13BAB893-27B5-457F-BADD-42D0AEB48DFA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8" creationId="{A677A872-7C46-4CD6-9761-FE98AAABB222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29" creationId="{CF4384DC-CF45-4FCD-813A-1F77F4702234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0" creationId="{068CBA70-B26C-4715-A683-0DDE721269B0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1" creationId="{A2E75444-9F68-418E-9FEB-C9EC584861F3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2" creationId="{6CC1586D-76FF-458F-AFA5-926724875179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3" creationId="{8BBEF7DD-69ED-4DA6-9216-CD7F78395300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4" creationId="{112C0779-C537-4953-99E5-C1D79601A396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5" creationId="{A128121E-ED3C-462A-AD55-1C1D9B645BD9}"/>
          </ac:spMkLst>
        </pc:spChg>
        <pc:spChg chg="mod">
          <ac:chgData name="Jung JungWon" userId="f625509f4158e876" providerId="LiveId" clId="{377065F7-8CD6-48A1-AA44-DD06E29EE015}" dt="2021-06-16T13:48:54.541" v="205" actId="14100"/>
          <ac:spMkLst>
            <pc:docMk/>
            <pc:sldMk cId="4109716099" sldId="257"/>
            <ac:spMk id="36" creationId="{301345C2-0A43-413A-8E83-37D8DB0AE7C8}"/>
          </ac:spMkLst>
        </pc:spChg>
        <pc:spChg chg="mod">
          <ac:chgData name="Jung JungWon" userId="f625509f4158e876" providerId="LiveId" clId="{377065F7-8CD6-48A1-AA44-DD06E29EE015}" dt="2021-06-16T13:48:49.985" v="204" actId="120"/>
          <ac:spMkLst>
            <pc:docMk/>
            <pc:sldMk cId="4109716099" sldId="257"/>
            <ac:spMk id="37" creationId="{7B8B1739-A860-419E-A913-520292C33658}"/>
          </ac:spMkLst>
        </pc:spChg>
        <pc:spChg chg="mod">
          <ac:chgData name="Jung JungWon" userId="f625509f4158e876" providerId="LiveId" clId="{377065F7-8CD6-48A1-AA44-DD06E29EE015}" dt="2021-06-16T13:48:49.985" v="204" actId="120"/>
          <ac:spMkLst>
            <pc:docMk/>
            <pc:sldMk cId="4109716099" sldId="257"/>
            <ac:spMk id="38" creationId="{7B3CFDC0-6216-459C-8FAF-C09328C2F3CC}"/>
          </ac:spMkLst>
        </pc:spChg>
        <pc:spChg chg="mod">
          <ac:chgData name="Jung JungWon" userId="f625509f4158e876" providerId="LiveId" clId="{377065F7-8CD6-48A1-AA44-DD06E29EE015}" dt="2021-06-16T13:48:28.470" v="200" actId="123"/>
          <ac:spMkLst>
            <pc:docMk/>
            <pc:sldMk cId="4109716099" sldId="257"/>
            <ac:spMk id="39" creationId="{3E2C92B3-62A8-4DFA-B285-1EE8B69B1F03}"/>
          </ac:spMkLst>
        </pc:spChg>
        <pc:grpChg chg="mod">
          <ac:chgData name="Jung JungWon" userId="f625509f4158e876" providerId="LiveId" clId="{377065F7-8CD6-48A1-AA44-DD06E29EE015}" dt="2021-06-16T13:48:54.541" v="205" actId="14100"/>
          <ac:grpSpMkLst>
            <pc:docMk/>
            <pc:sldMk cId="4109716099" sldId="257"/>
            <ac:grpSpMk id="2" creationId="{76CEDDEA-24D0-4A4D-88B7-16D2655763BC}"/>
          </ac:grpSpMkLst>
        </pc:grpChg>
        <pc:grpChg chg="mod">
          <ac:chgData name="Jung JungWon" userId="f625509f4158e876" providerId="LiveId" clId="{377065F7-8CD6-48A1-AA44-DD06E29EE015}" dt="2021-06-16T13:48:54.541" v="205" actId="14100"/>
          <ac:grpSpMkLst>
            <pc:docMk/>
            <pc:sldMk cId="4109716099" sldId="257"/>
            <ac:grpSpMk id="19" creationId="{F30B5E63-B3AC-4C57-B9A2-928EFCB9CAA8}"/>
          </ac:grpSpMkLst>
        </pc:grpChg>
        <pc:picChg chg="mod">
          <ac:chgData name="Jung JungWon" userId="f625509f4158e876" providerId="LiveId" clId="{377065F7-8CD6-48A1-AA44-DD06E29EE015}" dt="2021-06-16T13:48:54.541" v="205" actId="14100"/>
          <ac:picMkLst>
            <pc:docMk/>
            <pc:sldMk cId="4109716099" sldId="257"/>
            <ac:picMk id="3" creationId="{1A3FD842-5063-445E-BD15-68CDC10B9E15}"/>
          </ac:picMkLst>
        </pc:picChg>
        <pc:picChg chg="mod">
          <ac:chgData name="Jung JungWon" userId="f625509f4158e876" providerId="LiveId" clId="{377065F7-8CD6-48A1-AA44-DD06E29EE015}" dt="2021-06-16T13:48:54.541" v="205" actId="14100"/>
          <ac:picMkLst>
            <pc:docMk/>
            <pc:sldMk cId="4109716099" sldId="257"/>
            <ac:picMk id="20" creationId="{97D41AAE-91F8-4DFD-8BB7-2E180CBD2951}"/>
          </ac:picMkLst>
        </pc:picChg>
      </pc:sldChg>
      <pc:sldChg chg="modSp mod">
        <pc:chgData name="Jung JungWon" userId="f625509f4158e876" providerId="LiveId" clId="{377065F7-8CD6-48A1-AA44-DD06E29EE015}" dt="2021-06-16T13:38:41.382" v="77" actId="20577"/>
        <pc:sldMkLst>
          <pc:docMk/>
          <pc:sldMk cId="1720250174" sldId="259"/>
        </pc:sldMkLst>
        <pc:spChg chg="mod">
          <ac:chgData name="Jung JungWon" userId="f625509f4158e876" providerId="LiveId" clId="{377065F7-8CD6-48A1-AA44-DD06E29EE015}" dt="2021-06-16T13:38:41.382" v="77" actId="20577"/>
          <ac:spMkLst>
            <pc:docMk/>
            <pc:sldMk cId="1720250174" sldId="259"/>
            <ac:spMk id="4" creationId="{EF605B1E-46CB-4CDB-A271-95257C4FABF8}"/>
          </ac:spMkLst>
        </pc:spChg>
      </pc:sldChg>
      <pc:sldChg chg="addSp delSp modSp mod">
        <pc:chgData name="Jung JungWon" userId="f625509f4158e876" providerId="LiveId" clId="{377065F7-8CD6-48A1-AA44-DD06E29EE015}" dt="2021-06-16T13:46:41.426" v="163" actId="113"/>
        <pc:sldMkLst>
          <pc:docMk/>
          <pc:sldMk cId="2470623386" sldId="260"/>
        </pc:sldMkLst>
        <pc:spChg chg="mod">
          <ac:chgData name="Jung JungWon" userId="f625509f4158e876" providerId="LiveId" clId="{377065F7-8CD6-48A1-AA44-DD06E29EE015}" dt="2021-06-16T13:46:41.426" v="163" actId="113"/>
          <ac:spMkLst>
            <pc:docMk/>
            <pc:sldMk cId="2470623386" sldId="260"/>
            <ac:spMk id="5" creationId="{4F3B6EBE-286A-4297-9B07-A5283C62AF9F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19" creationId="{DB03C913-6388-4DF5-AA3B-8BA7064636BE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0" creationId="{E0565904-4A2F-4323-998E-2CE63C8437A3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1" creationId="{132410A6-F2B4-4323-BC80-D719F2ADD41B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2" creationId="{A8BB094A-366B-45F3-9BA8-BAF0B291D459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3" creationId="{CA9C05C7-E6BB-4057-A485-8813DECCAC61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4" creationId="{9083CDE7-36A6-4312-9865-2374A94B98C7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5" creationId="{B6AF38BC-2009-4631-B00E-22B2C440D9AF}"/>
          </ac:spMkLst>
        </pc:spChg>
        <pc:spChg chg="mod topLvl">
          <ac:chgData name="Jung JungWon" userId="f625509f4158e876" providerId="LiveId" clId="{377065F7-8CD6-48A1-AA44-DD06E29EE015}" dt="2021-06-16T13:40:40.182" v="93" actId="164"/>
          <ac:spMkLst>
            <pc:docMk/>
            <pc:sldMk cId="2470623386" sldId="260"/>
            <ac:spMk id="26" creationId="{760AEB59-FC01-4910-AE44-058C12FFCA42}"/>
          </ac:spMkLst>
        </pc:spChg>
        <pc:spChg chg="add mod">
          <ac:chgData name="Jung JungWon" userId="f625509f4158e876" providerId="LiveId" clId="{377065F7-8CD6-48A1-AA44-DD06E29EE015}" dt="2021-06-16T13:43:55.588" v="146" actId="1035"/>
          <ac:spMkLst>
            <pc:docMk/>
            <pc:sldMk cId="2470623386" sldId="260"/>
            <ac:spMk id="29" creationId="{C2D7C73F-4613-4032-89B6-6A1A3C2C5FB3}"/>
          </ac:spMkLst>
        </pc:spChg>
        <pc:spChg chg="mod ord">
          <ac:chgData name="Jung JungWon" userId="f625509f4158e876" providerId="LiveId" clId="{377065F7-8CD6-48A1-AA44-DD06E29EE015}" dt="2021-06-16T13:43:55.588" v="146" actId="1035"/>
          <ac:spMkLst>
            <pc:docMk/>
            <pc:sldMk cId="2470623386" sldId="260"/>
            <ac:spMk id="30" creationId="{8C7DE686-3C6F-4842-8778-32FAEEE0978D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3" creationId="{2DAB1602-28E5-4373-84FB-2D1F37AEAA79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4" creationId="{EA2F203C-866E-408A-AC88-90191CCC0557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5" creationId="{7594DA02-2200-442D-82A6-B37BD2E37FBD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6" creationId="{40263278-C78A-4E60-BF7F-CA0AAE460AE3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7" creationId="{DFC27557-B38D-4623-8270-4FDF63E765FD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8" creationId="{17FEB1A6-11DA-4871-BE4E-22CED400EC79}"/>
          </ac:spMkLst>
        </pc:spChg>
        <pc:spChg chg="mod">
          <ac:chgData name="Jung JungWon" userId="f625509f4158e876" providerId="LiveId" clId="{377065F7-8CD6-48A1-AA44-DD06E29EE015}" dt="2021-06-16T13:35:09.682" v="28" actId="164"/>
          <ac:spMkLst>
            <pc:docMk/>
            <pc:sldMk cId="2470623386" sldId="260"/>
            <ac:spMk id="39" creationId="{C66EE1E2-4F5C-4FB7-95D0-E74BE21351F8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45" creationId="{8EE58826-E7F1-4249-92EA-AE22A204651C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46" creationId="{759A030E-49D7-4BF1-A029-2220AED9D54E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47" creationId="{094A5187-6326-491F-9C62-FB18F8019CA4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48" creationId="{C31AF94F-CE36-4B73-9743-CCEE16108EE6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49" creationId="{84AD9278-D67D-4BF4-82F0-0E0491570077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50" creationId="{BA59D9D4-2101-41A9-8543-D2451FF51EC5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51" creationId="{CA17AFFB-DC48-41F5-B274-F7598E5C3754}"/>
          </ac:spMkLst>
        </pc:spChg>
        <pc:spChg chg="mod">
          <ac:chgData name="Jung JungWon" userId="f625509f4158e876" providerId="LiveId" clId="{377065F7-8CD6-48A1-AA44-DD06E29EE015}" dt="2021-06-16T13:42:04.839" v="112"/>
          <ac:spMkLst>
            <pc:docMk/>
            <pc:sldMk cId="2470623386" sldId="260"/>
            <ac:spMk id="52" creationId="{D345E5AE-D1AF-414A-9D91-1BAF41A2F43B}"/>
          </ac:spMkLst>
        </pc:spChg>
        <pc:grpChg chg="add del mod ord">
          <ac:chgData name="Jung JungWon" userId="f625509f4158e876" providerId="LiveId" clId="{377065F7-8CD6-48A1-AA44-DD06E29EE015}" dt="2021-06-16T13:41:00.061" v="95" actId="478"/>
          <ac:grpSpMkLst>
            <pc:docMk/>
            <pc:sldMk cId="2470623386" sldId="260"/>
            <ac:grpSpMk id="2" creationId="{914F1660-9049-4C73-A834-DC6CDBCCE394}"/>
          </ac:grpSpMkLst>
        </pc:grpChg>
        <pc:grpChg chg="add del mod">
          <ac:chgData name="Jung JungWon" userId="f625509f4158e876" providerId="LiveId" clId="{377065F7-8CD6-48A1-AA44-DD06E29EE015}" dt="2021-06-16T13:42:09.873" v="115" actId="478"/>
          <ac:grpSpMkLst>
            <pc:docMk/>
            <pc:sldMk cId="2470623386" sldId="260"/>
            <ac:grpSpMk id="3" creationId="{9EF1BDA2-D5B1-474F-B6BD-1FA5656B0562}"/>
          </ac:grpSpMkLst>
        </pc:grpChg>
        <pc:grpChg chg="add del mod ord">
          <ac:chgData name="Jung JungWon" userId="f625509f4158e876" providerId="LiveId" clId="{377065F7-8CD6-48A1-AA44-DD06E29EE015}" dt="2021-06-16T13:39:53.750" v="84" actId="165"/>
          <ac:grpSpMkLst>
            <pc:docMk/>
            <pc:sldMk cId="2470623386" sldId="260"/>
            <ac:grpSpMk id="15" creationId="{ED3FCFC1-9BD4-42E2-8A63-3347C85DA8FB}"/>
          </ac:grpSpMkLst>
        </pc:grpChg>
        <pc:grpChg chg="del mod topLvl">
          <ac:chgData name="Jung JungWon" userId="f625509f4158e876" providerId="LiveId" clId="{377065F7-8CD6-48A1-AA44-DD06E29EE015}" dt="2021-06-16T13:40:03.098" v="85" actId="165"/>
          <ac:grpSpMkLst>
            <pc:docMk/>
            <pc:sldMk cId="2470623386" sldId="260"/>
            <ac:grpSpMk id="17" creationId="{20FE6A77-BF18-4C6D-8D80-870E2E545C59}"/>
          </ac:grpSpMkLst>
        </pc:grpChg>
        <pc:grpChg chg="add del mod">
          <ac:chgData name="Jung JungWon" userId="f625509f4158e876" providerId="LiveId" clId="{377065F7-8CD6-48A1-AA44-DD06E29EE015}" dt="2021-06-16T13:42:07.083" v="113"/>
          <ac:grpSpMkLst>
            <pc:docMk/>
            <pc:sldMk cId="2470623386" sldId="260"/>
            <ac:grpSpMk id="42" creationId="{B9C3DA71-CAB3-4CCF-951B-ED211118409D}"/>
          </ac:grpSpMkLst>
        </pc:grpChg>
        <pc:picChg chg="add mod">
          <ac:chgData name="Jung JungWon" userId="f625509f4158e876" providerId="LiveId" clId="{377065F7-8CD6-48A1-AA44-DD06E29EE015}" dt="2021-06-16T13:44:02.913" v="153" actId="1037"/>
          <ac:picMkLst>
            <pc:docMk/>
            <pc:sldMk cId="2470623386" sldId="260"/>
            <ac:picMk id="4" creationId="{972A4AE8-FC71-4F06-9C77-0A2D6C40D0B1}"/>
          </ac:picMkLst>
        </pc:picChg>
        <pc:picChg chg="add mod ord">
          <ac:chgData name="Jung JungWon" userId="f625509f4158e876" providerId="LiveId" clId="{377065F7-8CD6-48A1-AA44-DD06E29EE015}" dt="2021-06-16T13:44:02.913" v="153" actId="1037"/>
          <ac:picMkLst>
            <pc:docMk/>
            <pc:sldMk cId="2470623386" sldId="260"/>
            <ac:picMk id="6" creationId="{F757B8CD-AD44-4785-AD20-CC675359F784}"/>
          </ac:picMkLst>
        </pc:picChg>
        <pc:picChg chg="mod">
          <ac:chgData name="Jung JungWon" userId="f625509f4158e876" providerId="LiveId" clId="{377065F7-8CD6-48A1-AA44-DD06E29EE015}" dt="2021-06-16T13:35:09.682" v="28" actId="164"/>
          <ac:picMkLst>
            <pc:docMk/>
            <pc:sldMk cId="2470623386" sldId="260"/>
            <ac:picMk id="9" creationId="{DE64444D-C0A9-43EF-BF2A-CD09A424EB5B}"/>
          </ac:picMkLst>
        </pc:picChg>
        <pc:picChg chg="mod topLvl modCrop">
          <ac:chgData name="Jung JungWon" userId="f625509f4158e876" providerId="LiveId" clId="{377065F7-8CD6-48A1-AA44-DD06E29EE015}" dt="2021-06-16T13:40:40.182" v="93" actId="164"/>
          <ac:picMkLst>
            <pc:docMk/>
            <pc:sldMk cId="2470623386" sldId="260"/>
            <ac:picMk id="16" creationId="{75B60D81-1E6F-441A-8ED1-3745161AECED}"/>
          </ac:picMkLst>
        </pc:picChg>
        <pc:picChg chg="mod topLvl modCrop">
          <ac:chgData name="Jung JungWon" userId="f625509f4158e876" providerId="LiveId" clId="{377065F7-8CD6-48A1-AA44-DD06E29EE015}" dt="2021-06-16T13:41:59.248" v="111" actId="1076"/>
          <ac:picMkLst>
            <pc:docMk/>
            <pc:sldMk cId="2470623386" sldId="260"/>
            <ac:picMk id="18" creationId="{E9189E9F-DE13-4141-B19F-504AB69D0825}"/>
          </ac:picMkLst>
        </pc:picChg>
        <pc:picChg chg="mod topLvl modCrop">
          <ac:chgData name="Jung JungWon" userId="f625509f4158e876" providerId="LiveId" clId="{377065F7-8CD6-48A1-AA44-DD06E29EE015}" dt="2021-06-16T13:40:40.182" v="93" actId="164"/>
          <ac:picMkLst>
            <pc:docMk/>
            <pc:sldMk cId="2470623386" sldId="260"/>
            <ac:picMk id="28" creationId="{F00D560A-8A9D-4391-82FA-F7C743DD93A9}"/>
          </ac:picMkLst>
        </pc:picChg>
        <pc:picChg chg="mod">
          <ac:chgData name="Jung JungWon" userId="f625509f4158e876" providerId="LiveId" clId="{377065F7-8CD6-48A1-AA44-DD06E29EE015}" dt="2021-06-16T13:35:09.682" v="28" actId="164"/>
          <ac:picMkLst>
            <pc:docMk/>
            <pc:sldMk cId="2470623386" sldId="260"/>
            <ac:picMk id="32" creationId="{A2DD25F8-028F-4A37-BB2C-939528A7DEDC}"/>
          </ac:picMkLst>
        </pc:picChg>
        <pc:picChg chg="add mod">
          <ac:chgData name="Jung JungWon" userId="f625509f4158e876" providerId="LiveId" clId="{377065F7-8CD6-48A1-AA44-DD06E29EE015}" dt="2021-06-16T13:41:11.719" v="100" actId="571"/>
          <ac:picMkLst>
            <pc:docMk/>
            <pc:sldMk cId="2470623386" sldId="260"/>
            <ac:picMk id="41" creationId="{5A505E7A-28F8-40B4-B02A-40EB12C2269A}"/>
          </ac:picMkLst>
        </pc:picChg>
        <pc:picChg chg="mod">
          <ac:chgData name="Jung JungWon" userId="f625509f4158e876" providerId="LiveId" clId="{377065F7-8CD6-48A1-AA44-DD06E29EE015}" dt="2021-06-16T13:42:04.839" v="112"/>
          <ac:picMkLst>
            <pc:docMk/>
            <pc:sldMk cId="2470623386" sldId="260"/>
            <ac:picMk id="43" creationId="{FB928DCA-F72A-4E7B-825E-B81783711434}"/>
          </ac:picMkLst>
        </pc:picChg>
        <pc:picChg chg="mod">
          <ac:chgData name="Jung JungWon" userId="f625509f4158e876" providerId="LiveId" clId="{377065F7-8CD6-48A1-AA44-DD06E29EE015}" dt="2021-06-16T13:42:04.839" v="112"/>
          <ac:picMkLst>
            <pc:docMk/>
            <pc:sldMk cId="2470623386" sldId="260"/>
            <ac:picMk id="44" creationId="{C6C68001-071B-4A0C-9D14-10C32C692A9B}"/>
          </ac:picMkLst>
        </pc:picChg>
        <pc:picChg chg="mod">
          <ac:chgData name="Jung JungWon" userId="f625509f4158e876" providerId="LiveId" clId="{377065F7-8CD6-48A1-AA44-DD06E29EE015}" dt="2021-06-16T13:42:04.839" v="112"/>
          <ac:picMkLst>
            <pc:docMk/>
            <pc:sldMk cId="2470623386" sldId="260"/>
            <ac:picMk id="54" creationId="{9527CD67-F4B0-490E-842A-31C8D544150A}"/>
          </ac:picMkLst>
        </pc:picChg>
        <pc:picChg chg="add mod">
          <ac:chgData name="Jung JungWon" userId="f625509f4158e876" providerId="LiveId" clId="{377065F7-8CD6-48A1-AA44-DD06E29EE015}" dt="2021-06-16T13:43:30.879" v="136" actId="571"/>
          <ac:picMkLst>
            <pc:docMk/>
            <pc:sldMk cId="2470623386" sldId="260"/>
            <ac:picMk id="55" creationId="{31205955-0FF9-4E8C-8755-A2080F8F8A9B}"/>
          </ac:picMkLst>
        </pc:picChg>
        <pc:picChg chg="add mod">
          <ac:chgData name="Jung JungWon" userId="f625509f4158e876" providerId="LiveId" clId="{377065F7-8CD6-48A1-AA44-DD06E29EE015}" dt="2021-06-16T13:43:30.879" v="136" actId="571"/>
          <ac:picMkLst>
            <pc:docMk/>
            <pc:sldMk cId="2470623386" sldId="260"/>
            <ac:picMk id="56" creationId="{77A83249-A8CC-4C91-B536-EDF5D1BEEE63}"/>
          </ac:picMkLst>
        </pc:picChg>
        <pc:cxnChg chg="mod topLvl">
          <ac:chgData name="Jung JungWon" userId="f625509f4158e876" providerId="LiveId" clId="{377065F7-8CD6-48A1-AA44-DD06E29EE015}" dt="2021-06-16T13:40:40.182" v="93" actId="164"/>
          <ac:cxnSpMkLst>
            <pc:docMk/>
            <pc:sldMk cId="2470623386" sldId="260"/>
            <ac:cxnSpMk id="27" creationId="{6A3996B9-6E27-405F-9A92-8E669C1EA366}"/>
          </ac:cxnSpMkLst>
        </pc:cxnChg>
        <pc:cxnChg chg="mod">
          <ac:chgData name="Jung JungWon" userId="f625509f4158e876" providerId="LiveId" clId="{377065F7-8CD6-48A1-AA44-DD06E29EE015}" dt="2021-06-16T13:35:09.682" v="28" actId="164"/>
          <ac:cxnSpMkLst>
            <pc:docMk/>
            <pc:sldMk cId="2470623386" sldId="260"/>
            <ac:cxnSpMk id="40" creationId="{8B0308E3-9EB6-4BB7-A969-D5C0BF749548}"/>
          </ac:cxnSpMkLst>
        </pc:cxnChg>
        <pc:cxnChg chg="mod">
          <ac:chgData name="Jung JungWon" userId="f625509f4158e876" providerId="LiveId" clId="{377065F7-8CD6-48A1-AA44-DD06E29EE015}" dt="2021-06-16T13:42:04.839" v="112"/>
          <ac:cxnSpMkLst>
            <pc:docMk/>
            <pc:sldMk cId="2470623386" sldId="260"/>
            <ac:cxnSpMk id="53" creationId="{8DE6DACD-BB55-43DF-8805-535B4F844FE6}"/>
          </ac:cxnSpMkLst>
        </pc:cxnChg>
      </pc:sldChg>
      <pc:sldChg chg="addSp delSp modSp del mod">
        <pc:chgData name="Jung JungWon" userId="f625509f4158e876" providerId="LiveId" clId="{377065F7-8CD6-48A1-AA44-DD06E29EE015}" dt="2021-06-16T13:47:07.292" v="164" actId="47"/>
        <pc:sldMkLst>
          <pc:docMk/>
          <pc:sldMk cId="3783846296" sldId="261"/>
        </pc:sldMkLst>
        <pc:spChg chg="del">
          <ac:chgData name="Jung JungWon" userId="f625509f4158e876" providerId="LiveId" clId="{377065F7-8CD6-48A1-AA44-DD06E29EE015}" dt="2021-06-16T13:35:14.205" v="31" actId="21"/>
          <ac:spMkLst>
            <pc:docMk/>
            <pc:sldMk cId="3783846296" sldId="261"/>
            <ac:spMk id="2" creationId="{86A731FB-9C71-45C3-B1DC-B52DCC6BA549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5" creationId="{B7C787F4-AB87-44B8-9C0A-92F72E44CCAD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6" creationId="{E16197AA-FBD3-4D8A-88ED-9B19FE7A141D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7" creationId="{73642D32-B7EB-4952-B542-D1026CFD76C8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8" creationId="{C5C8D23E-DFBC-4DB8-8056-476914EA215F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9" creationId="{DA3BD206-066D-4250-8C4C-3B150BB7239B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10" creationId="{14626E14-55A0-4108-BBEF-88B65ACB4605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11" creationId="{038DAAD9-BC0B-4814-8984-7B1334BDDBA1}"/>
          </ac:spMkLst>
        </pc:spChg>
        <pc:spChg chg="mod">
          <ac:chgData name="Jung JungWon" userId="f625509f4158e876" providerId="LiveId" clId="{377065F7-8CD6-48A1-AA44-DD06E29EE015}" dt="2021-06-16T13:31:54.667" v="4" actId="164"/>
          <ac:spMkLst>
            <pc:docMk/>
            <pc:sldMk cId="3783846296" sldId="261"/>
            <ac:spMk id="12" creationId="{0A6DA8FD-81C0-4475-9327-F25891A46280}"/>
          </ac:spMkLst>
        </pc:spChg>
        <pc:grpChg chg="add mod ord">
          <ac:chgData name="Jung JungWon" userId="f625509f4158e876" providerId="LiveId" clId="{377065F7-8CD6-48A1-AA44-DD06E29EE015}" dt="2021-06-16T13:34:02.458" v="20" actId="164"/>
          <ac:grpSpMkLst>
            <pc:docMk/>
            <pc:sldMk cId="3783846296" sldId="261"/>
            <ac:grpSpMk id="15" creationId="{62C5C548-C07B-4DA8-9AAF-5E396465D215}"/>
          </ac:grpSpMkLst>
        </pc:grpChg>
        <pc:grpChg chg="add del mod ord">
          <ac:chgData name="Jung JungWon" userId="f625509f4158e876" providerId="LiveId" clId="{377065F7-8CD6-48A1-AA44-DD06E29EE015}" dt="2021-06-16T13:35:14.205" v="31" actId="21"/>
          <ac:grpSpMkLst>
            <pc:docMk/>
            <pc:sldMk cId="3783846296" sldId="261"/>
            <ac:grpSpMk id="17" creationId="{FA44478D-EEE4-4B2D-A27E-8143BDA40AFC}"/>
          </ac:grpSpMkLst>
        </pc:grpChg>
        <pc:picChg chg="mod">
          <ac:chgData name="Jung JungWon" userId="f625509f4158e876" providerId="LiveId" clId="{377065F7-8CD6-48A1-AA44-DD06E29EE015}" dt="2021-06-16T13:31:54.667" v="4" actId="164"/>
          <ac:picMkLst>
            <pc:docMk/>
            <pc:sldMk cId="3783846296" sldId="261"/>
            <ac:picMk id="4" creationId="{DED4EF89-28E7-4302-818A-3024323CCD29}"/>
          </ac:picMkLst>
        </pc:picChg>
        <pc:picChg chg="mod">
          <ac:chgData name="Jung JungWon" userId="f625509f4158e876" providerId="LiveId" clId="{377065F7-8CD6-48A1-AA44-DD06E29EE015}" dt="2021-06-16T13:31:54.667" v="4" actId="164"/>
          <ac:picMkLst>
            <pc:docMk/>
            <pc:sldMk cId="3783846296" sldId="261"/>
            <ac:picMk id="14" creationId="{CC58E506-AFB6-4189-A96D-56ABE71E5632}"/>
          </ac:picMkLst>
        </pc:picChg>
        <pc:picChg chg="mod modCrop">
          <ac:chgData name="Jung JungWon" userId="f625509f4158e876" providerId="LiveId" clId="{377065F7-8CD6-48A1-AA44-DD06E29EE015}" dt="2021-06-16T13:34:02.458" v="20" actId="164"/>
          <ac:picMkLst>
            <pc:docMk/>
            <pc:sldMk cId="3783846296" sldId="261"/>
            <ac:picMk id="16" creationId="{CD544189-CFAB-42DC-B877-F539EB1B3089}"/>
          </ac:picMkLst>
        </pc:picChg>
        <pc:picChg chg="del mod">
          <ac:chgData name="Jung JungWon" userId="f625509f4158e876" providerId="LiveId" clId="{377065F7-8CD6-48A1-AA44-DD06E29EE015}" dt="2021-06-16T13:32:59.903" v="11" actId="478"/>
          <ac:picMkLst>
            <pc:docMk/>
            <pc:sldMk cId="3783846296" sldId="261"/>
            <ac:picMk id="18" creationId="{BEE0D41D-B61A-4B50-83BB-ED3ED284F0B6}"/>
          </ac:picMkLst>
        </pc:picChg>
        <pc:cxnChg chg="mod">
          <ac:chgData name="Jung JungWon" userId="f625509f4158e876" providerId="LiveId" clId="{377065F7-8CD6-48A1-AA44-DD06E29EE015}" dt="2021-06-16T13:31:54.667" v="4" actId="164"/>
          <ac:cxnSpMkLst>
            <pc:docMk/>
            <pc:sldMk cId="3783846296" sldId="261"/>
            <ac:cxnSpMk id="13" creationId="{325D128E-0578-400D-9676-DA2E25D8F72C}"/>
          </ac:cxnSpMkLst>
        </pc:cxnChg>
      </pc:sldChg>
    </pc:docChg>
  </pc:docChgLst>
  <pc:docChgLst>
    <pc:chgData name="Jung JungWon" userId="f625509f4158e876" providerId="LiveId" clId="{6E1364F6-311D-47E4-8CBA-47FA77C88F7E}"/>
    <pc:docChg chg="modSld">
      <pc:chgData name="Jung JungWon" userId="f625509f4158e876" providerId="LiveId" clId="{6E1364F6-311D-47E4-8CBA-47FA77C88F7E}" dt="2021-07-01T18:39:44.147" v="10" actId="1076"/>
      <pc:docMkLst>
        <pc:docMk/>
      </pc:docMkLst>
      <pc:sldChg chg="modSp mod">
        <pc:chgData name="Jung JungWon" userId="f625509f4158e876" providerId="LiveId" clId="{6E1364F6-311D-47E4-8CBA-47FA77C88F7E}" dt="2021-07-01T18:38:51.307" v="2" actId="1076"/>
        <pc:sldMkLst>
          <pc:docMk/>
          <pc:sldMk cId="2816437327" sldId="258"/>
        </pc:sldMkLst>
        <pc:spChg chg="mod">
          <ac:chgData name="Jung JungWon" userId="f625509f4158e876" providerId="LiveId" clId="{6E1364F6-311D-47E4-8CBA-47FA77C88F7E}" dt="2021-07-01T18:38:51.307" v="2" actId="1076"/>
          <ac:spMkLst>
            <pc:docMk/>
            <pc:sldMk cId="2816437327" sldId="258"/>
            <ac:spMk id="72" creationId="{199B7184-BD96-4517-83A3-2F73BF6D85D4}"/>
          </ac:spMkLst>
        </pc:spChg>
        <pc:picChg chg="mod">
          <ac:chgData name="Jung JungWon" userId="f625509f4158e876" providerId="LiveId" clId="{6E1364F6-311D-47E4-8CBA-47FA77C88F7E}" dt="2021-07-01T18:38:47.535" v="1" actId="14100"/>
          <ac:picMkLst>
            <pc:docMk/>
            <pc:sldMk cId="2816437327" sldId="258"/>
            <ac:picMk id="77" creationId="{8B00444D-C3A1-40E8-A535-F45861129ACA}"/>
          </ac:picMkLst>
        </pc:picChg>
      </pc:sldChg>
      <pc:sldChg chg="modSp mod">
        <pc:chgData name="Jung JungWon" userId="f625509f4158e876" providerId="LiveId" clId="{6E1364F6-311D-47E4-8CBA-47FA77C88F7E}" dt="2021-07-01T18:39:44.147" v="10" actId="1076"/>
        <pc:sldMkLst>
          <pc:docMk/>
          <pc:sldMk cId="1720250174" sldId="259"/>
        </pc:sldMkLst>
        <pc:spChg chg="mod">
          <ac:chgData name="Jung JungWon" userId="f625509f4158e876" providerId="LiveId" clId="{6E1364F6-311D-47E4-8CBA-47FA77C88F7E}" dt="2021-07-01T18:39:44.147" v="10" actId="1076"/>
          <ac:spMkLst>
            <pc:docMk/>
            <pc:sldMk cId="1720250174" sldId="259"/>
            <ac:spMk id="3" creationId="{81EE89C4-8210-43CF-92C8-A71A60188C83}"/>
          </ac:spMkLst>
        </pc:spChg>
        <pc:picChg chg="mod">
          <ac:chgData name="Jung JungWon" userId="f625509f4158e876" providerId="LiveId" clId="{6E1364F6-311D-47E4-8CBA-47FA77C88F7E}" dt="2021-07-01T18:39:30.327" v="7" actId="14100"/>
          <ac:picMkLst>
            <pc:docMk/>
            <pc:sldMk cId="1720250174" sldId="259"/>
            <ac:picMk id="2" creationId="{A30E078C-7378-4328-A8F1-6F54543BFDA7}"/>
          </ac:picMkLst>
        </pc:picChg>
      </pc:sldChg>
    </pc:docChg>
  </pc:docChgLst>
  <pc:docChgLst>
    <pc:chgData name="Jung JungWon" userId="f625509f4158e876" providerId="LiveId" clId="{164481B1-3A97-45C7-B704-97DEC26BF7FF}"/>
    <pc:docChg chg="undo custSel addSld modSld sldOrd">
      <pc:chgData name="Jung JungWon" userId="f625509f4158e876" providerId="LiveId" clId="{164481B1-3A97-45C7-B704-97DEC26BF7FF}" dt="2021-06-16T12:04:09.260" v="270" actId="1076"/>
      <pc:docMkLst>
        <pc:docMk/>
      </pc:docMkLst>
      <pc:sldChg chg="addSp delSp modSp">
        <pc:chgData name="Jung JungWon" userId="f625509f4158e876" providerId="LiveId" clId="{164481B1-3A97-45C7-B704-97DEC26BF7FF}" dt="2021-06-16T09:38:58.958" v="27"/>
        <pc:sldMkLst>
          <pc:docMk/>
          <pc:sldMk cId="3891717433" sldId="256"/>
        </pc:sldMkLst>
        <pc:spChg chg="add del mod">
          <ac:chgData name="Jung JungWon" userId="f625509f4158e876" providerId="LiveId" clId="{164481B1-3A97-45C7-B704-97DEC26BF7FF}" dt="2021-06-16T09:38:58.958" v="27"/>
          <ac:spMkLst>
            <pc:docMk/>
            <pc:sldMk cId="3891717433" sldId="256"/>
            <ac:spMk id="5" creationId="{0F3F3B5F-8512-4C0F-938E-F96458A8EDB7}"/>
          </ac:spMkLst>
        </pc:spChg>
        <pc:picChg chg="add del mod">
          <ac:chgData name="Jung JungWon" userId="f625509f4158e876" providerId="LiveId" clId="{164481B1-3A97-45C7-B704-97DEC26BF7FF}" dt="2021-06-16T09:38:58.958" v="27"/>
          <ac:picMkLst>
            <pc:docMk/>
            <pc:sldMk cId="3891717433" sldId="256"/>
            <ac:picMk id="4" creationId="{987EA5D0-B157-47F6-AE88-6335EE9C915D}"/>
          </ac:picMkLst>
        </pc:picChg>
      </pc:sldChg>
      <pc:sldChg chg="modSp mod">
        <pc:chgData name="Jung JungWon" userId="f625509f4158e876" providerId="LiveId" clId="{164481B1-3A97-45C7-B704-97DEC26BF7FF}" dt="2021-06-16T10:54:31.853" v="109" actId="20577"/>
        <pc:sldMkLst>
          <pc:docMk/>
          <pc:sldMk cId="4109716099" sldId="257"/>
        </pc:sldMkLst>
        <pc:spChg chg="mod">
          <ac:chgData name="Jung JungWon" userId="f625509f4158e876" providerId="LiveId" clId="{164481B1-3A97-45C7-B704-97DEC26BF7FF}" dt="2021-06-16T10:54:31.853" v="109" actId="20577"/>
          <ac:spMkLst>
            <pc:docMk/>
            <pc:sldMk cId="4109716099" sldId="257"/>
            <ac:spMk id="39" creationId="{3E2C92B3-62A8-4DFA-B285-1EE8B69B1F03}"/>
          </ac:spMkLst>
        </pc:spChg>
      </pc:sldChg>
      <pc:sldChg chg="addSp delSp modSp mod">
        <pc:chgData name="Jung JungWon" userId="f625509f4158e876" providerId="LiveId" clId="{164481B1-3A97-45C7-B704-97DEC26BF7FF}" dt="2021-06-16T10:48:28.980" v="59" actId="114"/>
        <pc:sldMkLst>
          <pc:docMk/>
          <pc:sldMk cId="2816437327" sldId="258"/>
        </pc:sldMkLst>
        <pc:spChg chg="mod">
          <ac:chgData name="Jung JungWon" userId="f625509f4158e876" providerId="LiveId" clId="{164481B1-3A97-45C7-B704-97DEC26BF7FF}" dt="2021-06-16T10:48:28.980" v="59" actId="114"/>
          <ac:spMkLst>
            <pc:docMk/>
            <pc:sldMk cId="2816437327" sldId="258"/>
            <ac:spMk id="2" creationId="{1420A141-ABCA-4C93-931B-9EC8469BEDDA}"/>
          </ac:spMkLst>
        </pc:spChg>
        <pc:spChg chg="mod">
          <ac:chgData name="Jung JungWon" userId="f625509f4158e876" providerId="LiveId" clId="{164481B1-3A97-45C7-B704-97DEC26BF7FF}" dt="2021-06-16T09:39:11.171" v="34" actId="1076"/>
          <ac:spMkLst>
            <pc:docMk/>
            <pc:sldMk cId="2816437327" sldId="258"/>
            <ac:spMk id="72" creationId="{199B7184-BD96-4517-83A3-2F73BF6D85D4}"/>
          </ac:spMkLst>
        </pc:spChg>
        <pc:spChg chg="del">
          <ac:chgData name="Jung JungWon" userId="f625509f4158e876" providerId="LiveId" clId="{164481B1-3A97-45C7-B704-97DEC26BF7FF}" dt="2021-06-16T09:38:57.131" v="25" actId="21"/>
          <ac:spMkLst>
            <pc:docMk/>
            <pc:sldMk cId="2816437327" sldId="258"/>
            <ac:spMk id="73" creationId="{89F42877-4940-4393-98DB-B916B1FD3CAC}"/>
          </ac:spMkLst>
        </pc:spChg>
        <pc:picChg chg="del mod modCrop">
          <ac:chgData name="Jung JungWon" userId="f625509f4158e876" providerId="LiveId" clId="{164481B1-3A97-45C7-B704-97DEC26BF7FF}" dt="2021-06-16T09:38:57.131" v="25" actId="21"/>
          <ac:picMkLst>
            <pc:docMk/>
            <pc:sldMk cId="2816437327" sldId="258"/>
            <ac:picMk id="71" creationId="{E5B80ABD-2A97-4225-AFCF-F32EE60DD556}"/>
          </ac:picMkLst>
        </pc:picChg>
        <pc:picChg chg="add del">
          <ac:chgData name="Jung JungWon" userId="f625509f4158e876" providerId="LiveId" clId="{164481B1-3A97-45C7-B704-97DEC26BF7FF}" dt="2021-06-16T09:37:28.581" v="8" actId="22"/>
          <ac:picMkLst>
            <pc:docMk/>
            <pc:sldMk cId="2816437327" sldId="258"/>
            <ac:picMk id="75" creationId="{112B5D55-87F9-4224-9463-0BD90BE673EE}"/>
          </ac:picMkLst>
        </pc:picChg>
        <pc:picChg chg="add del mod">
          <ac:chgData name="Jung JungWon" userId="f625509f4158e876" providerId="LiveId" clId="{164481B1-3A97-45C7-B704-97DEC26BF7FF}" dt="2021-06-16T09:37:35.098" v="10"/>
          <ac:picMkLst>
            <pc:docMk/>
            <pc:sldMk cId="2816437327" sldId="258"/>
            <ac:picMk id="76" creationId="{3134EFC1-E731-47C8-8AFE-81081F0ECAED}"/>
          </ac:picMkLst>
        </pc:picChg>
        <pc:picChg chg="add mod modCrop">
          <ac:chgData name="Jung JungWon" userId="f625509f4158e876" providerId="LiveId" clId="{164481B1-3A97-45C7-B704-97DEC26BF7FF}" dt="2021-06-16T09:39:11.171" v="34" actId="1076"/>
          <ac:picMkLst>
            <pc:docMk/>
            <pc:sldMk cId="2816437327" sldId="258"/>
            <ac:picMk id="77" creationId="{8B00444D-C3A1-40E8-A535-F45861129ACA}"/>
          </ac:picMkLst>
        </pc:picChg>
      </pc:sldChg>
      <pc:sldChg chg="addSp modSp mod ord">
        <pc:chgData name="Jung JungWon" userId="f625509f4158e876" providerId="LiveId" clId="{164481B1-3A97-45C7-B704-97DEC26BF7FF}" dt="2021-06-16T10:53:05.038" v="66"/>
        <pc:sldMkLst>
          <pc:docMk/>
          <pc:sldMk cId="1720250174" sldId="259"/>
        </pc:sldMkLst>
        <pc:spChg chg="add mod">
          <ac:chgData name="Jung JungWon" userId="f625509f4158e876" providerId="LiveId" clId="{164481B1-3A97-45C7-B704-97DEC26BF7FF}" dt="2021-06-16T09:39:06.961" v="33" actId="1076"/>
          <ac:spMkLst>
            <pc:docMk/>
            <pc:sldMk cId="1720250174" sldId="259"/>
            <ac:spMk id="3" creationId="{81EE89C4-8210-43CF-92C8-A71A60188C83}"/>
          </ac:spMkLst>
        </pc:spChg>
        <pc:spChg chg="add mod">
          <ac:chgData name="Jung JungWon" userId="f625509f4158e876" providerId="LiveId" clId="{164481B1-3A97-45C7-B704-97DEC26BF7FF}" dt="2021-06-16T10:53:05.038" v="66"/>
          <ac:spMkLst>
            <pc:docMk/>
            <pc:sldMk cId="1720250174" sldId="259"/>
            <ac:spMk id="4" creationId="{EF605B1E-46CB-4CDB-A271-95257C4FABF8}"/>
          </ac:spMkLst>
        </pc:spChg>
        <pc:picChg chg="add mod">
          <ac:chgData name="Jung JungWon" userId="f625509f4158e876" providerId="LiveId" clId="{164481B1-3A97-45C7-B704-97DEC26BF7FF}" dt="2021-06-16T09:39:06.961" v="33" actId="1076"/>
          <ac:picMkLst>
            <pc:docMk/>
            <pc:sldMk cId="1720250174" sldId="259"/>
            <ac:picMk id="2" creationId="{A30E078C-7378-4328-A8F1-6F54543BFDA7}"/>
          </ac:picMkLst>
        </pc:picChg>
      </pc:sldChg>
      <pc:sldChg chg="addSp delSp modSp new mod">
        <pc:chgData name="Jung JungWon" userId="f625509f4158e876" providerId="LiveId" clId="{164481B1-3A97-45C7-B704-97DEC26BF7FF}" dt="2021-06-16T11:58:09.120" v="209" actId="20577"/>
        <pc:sldMkLst>
          <pc:docMk/>
          <pc:sldMk cId="2470623386" sldId="260"/>
        </pc:sldMkLst>
        <pc:spChg chg="add del mod">
          <ac:chgData name="Jung JungWon" userId="f625509f4158e876" providerId="LiveId" clId="{164481B1-3A97-45C7-B704-97DEC26BF7FF}" dt="2021-06-16T11:40:35.812" v="123" actId="478"/>
          <ac:spMkLst>
            <pc:docMk/>
            <pc:sldMk cId="2470623386" sldId="260"/>
            <ac:spMk id="3" creationId="{1754CE11-DEF5-4610-8BF1-FDB119A27605}"/>
          </ac:spMkLst>
        </pc:spChg>
        <pc:spChg chg="add mod">
          <ac:chgData name="Jung JungWon" userId="f625509f4158e876" providerId="LiveId" clId="{164481B1-3A97-45C7-B704-97DEC26BF7FF}" dt="2021-06-16T11:58:09.120" v="209" actId="20577"/>
          <ac:spMkLst>
            <pc:docMk/>
            <pc:sldMk cId="2470623386" sldId="260"/>
            <ac:spMk id="5" creationId="{4F3B6EBE-286A-4297-9B07-A5283C62AF9F}"/>
          </ac:spMkLst>
        </pc:spChg>
        <pc:spChg chg="add del mod">
          <ac:chgData name="Jung JungWon" userId="f625509f4158e876" providerId="LiveId" clId="{164481B1-3A97-45C7-B704-97DEC26BF7FF}" dt="2021-06-16T11:41:30.037" v="132" actId="478"/>
          <ac:spMkLst>
            <pc:docMk/>
            <pc:sldMk cId="2470623386" sldId="260"/>
            <ac:spMk id="7" creationId="{7AD0FEA4-358F-4AC8-8772-431BCDEA1F0B}"/>
          </ac:spMkLst>
        </pc:spChg>
        <pc:spChg chg="del mod topLvl">
          <ac:chgData name="Jung JungWon" userId="f625509f4158e876" providerId="LiveId" clId="{164481B1-3A97-45C7-B704-97DEC26BF7FF}" dt="2021-06-16T11:49:10.491" v="195" actId="478"/>
          <ac:spMkLst>
            <pc:docMk/>
            <pc:sldMk cId="2470623386" sldId="260"/>
            <ac:spMk id="10" creationId="{EB821906-B993-4679-B651-B680D2519158}"/>
          </ac:spMkLst>
        </pc:spChg>
        <pc:spChg chg="del mod topLvl">
          <ac:chgData name="Jung JungWon" userId="f625509f4158e876" providerId="LiveId" clId="{164481B1-3A97-45C7-B704-97DEC26BF7FF}" dt="2021-06-16T11:49:11.510" v="196" actId="478"/>
          <ac:spMkLst>
            <pc:docMk/>
            <pc:sldMk cId="2470623386" sldId="260"/>
            <ac:spMk id="11" creationId="{AA3F90CA-84E0-45C0-8274-C2A559F742B8}"/>
          </ac:spMkLst>
        </pc:spChg>
        <pc:spChg chg="del mod topLvl">
          <ac:chgData name="Jung JungWon" userId="f625509f4158e876" providerId="LiveId" clId="{164481B1-3A97-45C7-B704-97DEC26BF7FF}" dt="2021-06-16T11:48:57.001" v="191" actId="478"/>
          <ac:spMkLst>
            <pc:docMk/>
            <pc:sldMk cId="2470623386" sldId="260"/>
            <ac:spMk id="12" creationId="{94273327-D79C-4102-BAB2-695D08835B32}"/>
          </ac:spMkLst>
        </pc:spChg>
        <pc:spChg chg="del mod topLvl">
          <ac:chgData name="Jung JungWon" userId="f625509f4158e876" providerId="LiveId" clId="{164481B1-3A97-45C7-B704-97DEC26BF7FF}" dt="2021-06-16T11:48:57.001" v="191" actId="478"/>
          <ac:spMkLst>
            <pc:docMk/>
            <pc:sldMk cId="2470623386" sldId="260"/>
            <ac:spMk id="13" creationId="{7668E849-FC92-4237-83B1-692D5E4FE00E}"/>
          </ac:spMkLst>
        </pc:spChg>
        <pc:spChg chg="del mod topLvl">
          <ac:chgData name="Jung JungWon" userId="f625509f4158e876" providerId="LiveId" clId="{164481B1-3A97-45C7-B704-97DEC26BF7FF}" dt="2021-06-16T11:48:57.001" v="191" actId="478"/>
          <ac:spMkLst>
            <pc:docMk/>
            <pc:sldMk cId="2470623386" sldId="260"/>
            <ac:spMk id="14" creationId="{41F59A9A-15C5-441F-8E23-9AB2CE082875}"/>
          </ac:spMkLst>
        </pc:spChg>
        <pc:spChg chg="del mod topLvl">
          <ac:chgData name="Jung JungWon" userId="f625509f4158e876" providerId="LiveId" clId="{164481B1-3A97-45C7-B704-97DEC26BF7FF}" dt="2021-06-16T11:48:57.001" v="191" actId="478"/>
          <ac:spMkLst>
            <pc:docMk/>
            <pc:sldMk cId="2470623386" sldId="260"/>
            <ac:spMk id="15" creationId="{556A8AC6-D637-466A-8D8F-28101F198BE4}"/>
          </ac:spMkLst>
        </pc:spChg>
        <pc:spChg chg="del mod topLvl">
          <ac:chgData name="Jung JungWon" userId="f625509f4158e876" providerId="LiveId" clId="{164481B1-3A97-45C7-B704-97DEC26BF7FF}" dt="2021-06-16T11:48:57.001" v="191" actId="478"/>
          <ac:spMkLst>
            <pc:docMk/>
            <pc:sldMk cId="2470623386" sldId="260"/>
            <ac:spMk id="16" creationId="{32C200BD-AB37-4E9C-B0C7-3058474E8BD6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1" creationId="{733315E5-97CA-4589-A255-863293C00387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2" creationId="{AB76E6BA-108C-4758-8255-287E67D22F90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3" creationId="{F30E425F-6B58-4344-858F-7440A558EDBE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4" creationId="{E0805552-3E96-4AAC-82C1-BDB26F3AEE4B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5" creationId="{9EF3BAAA-1F56-47A5-8D08-33025073F4C8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6" creationId="{8C921941-A99A-4D1B-9C10-285BD06EF218}"/>
          </ac:spMkLst>
        </pc:spChg>
        <pc:spChg chg="del mod topLvl">
          <ac:chgData name="Jung JungWon" userId="f625509f4158e876" providerId="LiveId" clId="{164481B1-3A97-45C7-B704-97DEC26BF7FF}" dt="2021-06-16T11:43:43.141" v="143" actId="478"/>
          <ac:spMkLst>
            <pc:docMk/>
            <pc:sldMk cId="2470623386" sldId="260"/>
            <ac:spMk id="27" creationId="{13681F06-1B6E-4FAA-8047-DB29117BFA02}"/>
          </ac:spMkLst>
        </pc:spChg>
        <pc:spChg chg="add mod">
          <ac:chgData name="Jung JungWon" userId="f625509f4158e876" providerId="LiveId" clId="{164481B1-3A97-45C7-B704-97DEC26BF7FF}" dt="2021-06-16T11:46:32.119" v="175" actId="1076"/>
          <ac:spMkLst>
            <pc:docMk/>
            <pc:sldMk cId="2470623386" sldId="260"/>
            <ac:spMk id="30" creationId="{8C7DE686-3C6F-4842-8778-32FAEEE0978D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3" creationId="{2DAB1602-28E5-4373-84FB-2D1F37AEAA79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4" creationId="{EA2F203C-866E-408A-AC88-90191CCC0557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5" creationId="{7594DA02-2200-442D-82A6-B37BD2E37FBD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6" creationId="{40263278-C78A-4E60-BF7F-CA0AAE460AE3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7" creationId="{DFC27557-B38D-4623-8270-4FDF63E765FD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8" creationId="{17FEB1A6-11DA-4871-BE4E-22CED400EC79}"/>
          </ac:spMkLst>
        </pc:spChg>
        <pc:spChg chg="mod topLvl">
          <ac:chgData name="Jung JungWon" userId="f625509f4158e876" providerId="LiveId" clId="{164481B1-3A97-45C7-B704-97DEC26BF7FF}" dt="2021-06-16T11:48:26.447" v="187" actId="1076"/>
          <ac:spMkLst>
            <pc:docMk/>
            <pc:sldMk cId="2470623386" sldId="260"/>
            <ac:spMk id="39" creationId="{C66EE1E2-4F5C-4FB7-95D0-E74BE21351F8}"/>
          </ac:spMkLst>
        </pc:spChg>
        <pc:grpChg chg="add del mod">
          <ac:chgData name="Jung JungWon" userId="f625509f4158e876" providerId="LiveId" clId="{164481B1-3A97-45C7-B704-97DEC26BF7FF}" dt="2021-06-16T11:47:52.653" v="181" actId="165"/>
          <ac:grpSpMkLst>
            <pc:docMk/>
            <pc:sldMk cId="2470623386" sldId="260"/>
            <ac:grpSpMk id="8" creationId="{93D4DEA0-3628-42ED-9DE8-AF179CB0C1AF}"/>
          </ac:grpSpMkLst>
        </pc:grpChg>
        <pc:grpChg chg="add del mod">
          <ac:chgData name="Jung JungWon" userId="f625509f4158e876" providerId="LiveId" clId="{164481B1-3A97-45C7-B704-97DEC26BF7FF}" dt="2021-06-16T11:43:39.653" v="142" actId="165"/>
          <ac:grpSpMkLst>
            <pc:docMk/>
            <pc:sldMk cId="2470623386" sldId="260"/>
            <ac:grpSpMk id="19" creationId="{0EFF551C-35BF-4C18-9DC7-5597EE5C9EA0}"/>
          </ac:grpSpMkLst>
        </pc:grpChg>
        <pc:grpChg chg="add mod">
          <ac:chgData name="Jung JungWon" userId="f625509f4158e876" providerId="LiveId" clId="{164481B1-3A97-45C7-B704-97DEC26BF7FF}" dt="2021-06-16T11:46:10.306" v="170" actId="164"/>
          <ac:grpSpMkLst>
            <pc:docMk/>
            <pc:sldMk cId="2470623386" sldId="260"/>
            <ac:grpSpMk id="29" creationId="{AB230715-DC65-4BE0-8F1F-FF0E7BD14783}"/>
          </ac:grpSpMkLst>
        </pc:grpChg>
        <pc:grpChg chg="add del mod">
          <ac:chgData name="Jung JungWon" userId="f625509f4158e876" providerId="LiveId" clId="{164481B1-3A97-45C7-B704-97DEC26BF7FF}" dt="2021-06-16T11:47:00.178" v="177" actId="165"/>
          <ac:grpSpMkLst>
            <pc:docMk/>
            <pc:sldMk cId="2470623386" sldId="260"/>
            <ac:grpSpMk id="31" creationId="{771A4BB7-5FFA-490C-AD81-3A2348582591}"/>
          </ac:grpSpMkLst>
        </pc:grpChg>
        <pc:picChg chg="add del mod">
          <ac:chgData name="Jung JungWon" userId="f625509f4158e876" providerId="LiveId" clId="{164481B1-3A97-45C7-B704-97DEC26BF7FF}" dt="2021-06-16T11:41:59.669" v="136" actId="478"/>
          <ac:picMkLst>
            <pc:docMk/>
            <pc:sldMk cId="2470623386" sldId="260"/>
            <ac:picMk id="4" creationId="{BE93DE61-4FAA-451A-B520-8E56CC040CC5}"/>
          </ac:picMkLst>
        </pc:picChg>
        <pc:picChg chg="add del mod modCrop">
          <ac:chgData name="Jung JungWon" userId="f625509f4158e876" providerId="LiveId" clId="{164481B1-3A97-45C7-B704-97DEC26BF7FF}" dt="2021-06-16T11:41:58.714" v="135" actId="478"/>
          <ac:picMkLst>
            <pc:docMk/>
            <pc:sldMk cId="2470623386" sldId="260"/>
            <ac:picMk id="6" creationId="{A5CB587E-6C0E-4524-BC55-6801B9C22CEF}"/>
          </ac:picMkLst>
        </pc:picChg>
        <pc:picChg chg="mod topLvl modCrop">
          <ac:chgData name="Jung JungWon" userId="f625509f4158e876" providerId="LiveId" clId="{164481B1-3A97-45C7-B704-97DEC26BF7FF}" dt="2021-06-16T11:48:33.103" v="189" actId="1036"/>
          <ac:picMkLst>
            <pc:docMk/>
            <pc:sldMk cId="2470623386" sldId="260"/>
            <ac:picMk id="9" creationId="{DE64444D-C0A9-43EF-BF2A-CD09A424EB5B}"/>
          </ac:picMkLst>
        </pc:picChg>
        <pc:picChg chg="add del mod">
          <ac:chgData name="Jung JungWon" userId="f625509f4158e876" providerId="LiveId" clId="{164481B1-3A97-45C7-B704-97DEC26BF7FF}" dt="2021-06-16T11:43:33.584" v="140" actId="478"/>
          <ac:picMkLst>
            <pc:docMk/>
            <pc:sldMk cId="2470623386" sldId="260"/>
            <ac:picMk id="18" creationId="{9A94FDD9-9220-4134-980F-5F48831EA58A}"/>
          </ac:picMkLst>
        </pc:picChg>
        <pc:picChg chg="del mod topLvl modCrop">
          <ac:chgData name="Jung JungWon" userId="f625509f4158e876" providerId="LiveId" clId="{164481B1-3A97-45C7-B704-97DEC26BF7FF}" dt="2021-06-16T11:48:11.343" v="184" actId="478"/>
          <ac:picMkLst>
            <pc:docMk/>
            <pc:sldMk cId="2470623386" sldId="260"/>
            <ac:picMk id="20" creationId="{2C05DBCE-8D17-41AF-829B-3D3E33BF1CE6}"/>
          </ac:picMkLst>
        </pc:picChg>
        <pc:picChg chg="mod ord topLvl modCrop">
          <ac:chgData name="Jung JungWon" userId="f625509f4158e876" providerId="LiveId" clId="{164481B1-3A97-45C7-B704-97DEC26BF7FF}" dt="2021-06-16T11:49:14.617" v="197" actId="1076"/>
          <ac:picMkLst>
            <pc:docMk/>
            <pc:sldMk cId="2470623386" sldId="260"/>
            <ac:picMk id="32" creationId="{A2DD25F8-028F-4A37-BB2C-939528A7DEDC}"/>
          </ac:picMkLst>
        </pc:picChg>
        <pc:cxnChg chg="del mod topLvl">
          <ac:chgData name="Jung JungWon" userId="f625509f4158e876" providerId="LiveId" clId="{164481B1-3A97-45C7-B704-97DEC26BF7FF}" dt="2021-06-16T11:48:57.001" v="191" actId="478"/>
          <ac:cxnSpMkLst>
            <pc:docMk/>
            <pc:sldMk cId="2470623386" sldId="260"/>
            <ac:cxnSpMk id="17" creationId="{BD16A81D-AA44-41BE-82EB-D9ECD04C7A12}"/>
          </ac:cxnSpMkLst>
        </pc:cxnChg>
        <pc:cxnChg chg="del mod topLvl">
          <ac:chgData name="Jung JungWon" userId="f625509f4158e876" providerId="LiveId" clId="{164481B1-3A97-45C7-B704-97DEC26BF7FF}" dt="2021-06-16T11:43:43.141" v="143" actId="478"/>
          <ac:cxnSpMkLst>
            <pc:docMk/>
            <pc:sldMk cId="2470623386" sldId="260"/>
            <ac:cxnSpMk id="28" creationId="{071B6B84-4561-4C4B-9FCB-FAFE2A8D1847}"/>
          </ac:cxnSpMkLst>
        </pc:cxnChg>
        <pc:cxnChg chg="mod topLvl">
          <ac:chgData name="Jung JungWon" userId="f625509f4158e876" providerId="LiveId" clId="{164481B1-3A97-45C7-B704-97DEC26BF7FF}" dt="2021-06-16T11:48:26.447" v="187" actId="1076"/>
          <ac:cxnSpMkLst>
            <pc:docMk/>
            <pc:sldMk cId="2470623386" sldId="260"/>
            <ac:cxnSpMk id="40" creationId="{8B0308E3-9EB6-4BB7-A969-D5C0BF749548}"/>
          </ac:cxnSpMkLst>
        </pc:cxnChg>
      </pc:sldChg>
      <pc:sldChg chg="addSp delSp modSp new mod">
        <pc:chgData name="Jung JungWon" userId="f625509f4158e876" providerId="LiveId" clId="{164481B1-3A97-45C7-B704-97DEC26BF7FF}" dt="2021-06-16T12:04:09.260" v="270" actId="1076"/>
        <pc:sldMkLst>
          <pc:docMk/>
          <pc:sldMk cId="3783846296" sldId="261"/>
        </pc:sldMkLst>
        <pc:spChg chg="add mod">
          <ac:chgData name="Jung JungWon" userId="f625509f4158e876" providerId="LiveId" clId="{164481B1-3A97-45C7-B704-97DEC26BF7FF}" dt="2021-06-16T11:58:40.653" v="215" actId="1076"/>
          <ac:spMkLst>
            <pc:docMk/>
            <pc:sldMk cId="3783846296" sldId="261"/>
            <ac:spMk id="2" creationId="{86A731FB-9C71-45C3-B1DC-B52DCC6BA549}"/>
          </ac:spMkLst>
        </pc:spChg>
        <pc:spChg chg="add mod">
          <ac:chgData name="Jung JungWon" userId="f625509f4158e876" providerId="LiveId" clId="{164481B1-3A97-45C7-B704-97DEC26BF7FF}" dt="2021-06-16T12:04:09.260" v="270" actId="1076"/>
          <ac:spMkLst>
            <pc:docMk/>
            <pc:sldMk cId="3783846296" sldId="261"/>
            <ac:spMk id="3" creationId="{96113987-511F-432D-9D66-3FE7703E2C5A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5" creationId="{B7C787F4-AB87-44B8-9C0A-92F72E44CCAD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6" creationId="{E16197AA-FBD3-4D8A-88ED-9B19FE7A141D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7" creationId="{73642D32-B7EB-4952-B542-D1026CFD76C8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8" creationId="{C5C8D23E-DFBC-4DB8-8056-476914EA215F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9" creationId="{DA3BD206-066D-4250-8C4C-3B150BB7239B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10" creationId="{14626E14-55A0-4108-BBEF-88B65ACB4605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11" creationId="{038DAAD9-BC0B-4814-8984-7B1334BDDBA1}"/>
          </ac:spMkLst>
        </pc:spChg>
        <pc:spChg chg="add mod ord">
          <ac:chgData name="Jung JungWon" userId="f625509f4158e876" providerId="LiveId" clId="{164481B1-3A97-45C7-B704-97DEC26BF7FF}" dt="2021-06-16T12:03:07.545" v="259" actId="1076"/>
          <ac:spMkLst>
            <pc:docMk/>
            <pc:sldMk cId="3783846296" sldId="261"/>
            <ac:spMk id="12" creationId="{0A6DA8FD-81C0-4475-9327-F25891A46280}"/>
          </ac:spMkLst>
        </pc:spChg>
        <pc:picChg chg="add mod ord modCrop">
          <ac:chgData name="Jung JungWon" userId="f625509f4158e876" providerId="LiveId" clId="{164481B1-3A97-45C7-B704-97DEC26BF7FF}" dt="2021-06-16T12:03:13.477" v="261" actId="1035"/>
          <ac:picMkLst>
            <pc:docMk/>
            <pc:sldMk cId="3783846296" sldId="261"/>
            <ac:picMk id="4" creationId="{DED4EF89-28E7-4302-818A-3024323CCD29}"/>
          </ac:picMkLst>
        </pc:picChg>
        <pc:picChg chg="add mod modCrop">
          <ac:chgData name="Jung JungWon" userId="f625509f4158e876" providerId="LiveId" clId="{164481B1-3A97-45C7-B704-97DEC26BF7FF}" dt="2021-06-16T12:03:50.109" v="267" actId="1035"/>
          <ac:picMkLst>
            <pc:docMk/>
            <pc:sldMk cId="3783846296" sldId="261"/>
            <ac:picMk id="14" creationId="{CC58E506-AFB6-4189-A96D-56ABE71E5632}"/>
          </ac:picMkLst>
        </pc:picChg>
        <pc:picChg chg="add del mod modCrop">
          <ac:chgData name="Jung JungWon" userId="f625509f4158e876" providerId="LiveId" clId="{164481B1-3A97-45C7-B704-97DEC26BF7FF}" dt="2021-06-16T12:01:26.116" v="237" actId="478"/>
          <ac:picMkLst>
            <pc:docMk/>
            <pc:sldMk cId="3783846296" sldId="261"/>
            <ac:picMk id="15" creationId="{6053BF15-5EF2-4B8B-88CB-99AB6DC669D4}"/>
          </ac:picMkLst>
        </pc:picChg>
        <pc:picChg chg="add mod modCrop">
          <ac:chgData name="Jung JungWon" userId="f625509f4158e876" providerId="LiveId" clId="{164481B1-3A97-45C7-B704-97DEC26BF7FF}" dt="2021-06-16T12:03:38.878" v="263" actId="1035"/>
          <ac:picMkLst>
            <pc:docMk/>
            <pc:sldMk cId="3783846296" sldId="261"/>
            <ac:picMk id="16" creationId="{CD544189-CFAB-42DC-B877-F539EB1B3089}"/>
          </ac:picMkLst>
        </pc:picChg>
        <pc:picChg chg="add del mod">
          <ac:chgData name="Jung JungWon" userId="f625509f4158e876" providerId="LiveId" clId="{164481B1-3A97-45C7-B704-97DEC26BF7FF}" dt="2021-06-16T12:02:31.756" v="249" actId="478"/>
          <ac:picMkLst>
            <pc:docMk/>
            <pc:sldMk cId="3783846296" sldId="261"/>
            <ac:picMk id="17" creationId="{B3DAC6BB-89E3-4C4E-B61D-7BC91E9873DC}"/>
          </ac:picMkLst>
        </pc:picChg>
        <pc:picChg chg="add mod modCrop">
          <ac:chgData name="Jung JungWon" userId="f625509f4158e876" providerId="LiveId" clId="{164481B1-3A97-45C7-B704-97DEC26BF7FF}" dt="2021-06-16T12:03:44.114" v="266" actId="1035"/>
          <ac:picMkLst>
            <pc:docMk/>
            <pc:sldMk cId="3783846296" sldId="261"/>
            <ac:picMk id="18" creationId="{BEE0D41D-B61A-4B50-83BB-ED3ED284F0B6}"/>
          </ac:picMkLst>
        </pc:picChg>
        <pc:cxnChg chg="add mod ord">
          <ac:chgData name="Jung JungWon" userId="f625509f4158e876" providerId="LiveId" clId="{164481B1-3A97-45C7-B704-97DEC26BF7FF}" dt="2021-06-16T12:03:07.545" v="259" actId="1076"/>
          <ac:cxnSpMkLst>
            <pc:docMk/>
            <pc:sldMk cId="3783846296" sldId="261"/>
            <ac:cxnSpMk id="13" creationId="{325D128E-0578-400D-9676-DA2E25D8F72C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842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4895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5981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599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6886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755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9945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5374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2601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590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1716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89274-5671-489F-9643-8FD4E51A9AFE}" type="datetimeFigureOut">
              <a:rPr lang="ko-KR" altLang="en-US" smtClean="0"/>
              <a:t>2021-09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EC19A-9999-43A0-BC85-74E4D8ECBF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76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614772" y="2924324"/>
            <a:ext cx="8658708" cy="3933676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</a:p>
          <a:p>
            <a:pPr marL="0" indent="0" algn="ctr">
              <a:lnSpc>
                <a:spcPct val="100000"/>
              </a:lnSpc>
              <a:buNone/>
            </a:pP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latinLnBrk="1">
              <a:lnSpc>
                <a:spcPct val="100000"/>
              </a:lnSpc>
              <a:buFont typeface="+mj-lt"/>
              <a:buAutoNum type="arabicPeriod"/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1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C-TOF-MS analytical ion chromatogram (AIC) of hydrophilic compounds extracted from BCE seed (A) and leaf (B). 1, Pyruvic acid; 2, Lactic acid; 3, Alanine; 4, Oxalic acid; 5, Valine; 6, Urea; 7, Serine-1; 8, Glycerol; 9, Ethanolamine; 10, Leucine; 11, Phosphoric acid; 12, Isoleucine; 13, Proline; 14, Succinic acid; 15, Glycine; 16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lycer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17, Fumaric acid; 18, Serine-2; 19, Threonine; 20, β-Alanine; 21, Malic acid ; 22, Aspartic acid; 23, Methionine; 24, γ-Aminobutyric acid; 25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hreon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26, Glutamic acid; 27, Phenylalanine; 28, Xylose; 29, Arabinose; 30, Asparagine; 31, Xylitol; 32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Ribitol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; 33, Glutamine; 34, Shikimic acid; 35, Citric acid; 36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Quin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37, Fructose-1; 38, Fructose-2; 39, Mannose; 40, Galactose-1; 41, Glucose-1; 42, Lysine; 43, Ferulic acid; 44, Glucose-2; 45, Mannitol; 46, p-Coumaric acid; 47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inapin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48, Inositol; 49, Tryptophane; 50, Sucrose; 51, Raffinose; 52, Stachyose.</a:t>
            </a:r>
            <a:endParaRPr lang="ko-KR" altLang="ko-KR" sz="1200" kern="100" dirty="0">
              <a:effectLst/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 latinLnBrk="1">
              <a:lnSpc>
                <a:spcPct val="100000"/>
              </a:lnSpc>
              <a:buFont typeface="+mj-lt"/>
              <a:buAutoNum type="arabicPeriod"/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2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HPLC chromatogram of carotenoid compounds from seed (A) and leaf (B). Peak: 1, Violaxanthin; 2, Lutein; 3, Zeaxanthin; 4, trans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Apo-8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al (IS); 5, 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ryptoxanthin; 6, 13Z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; 7, 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α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; 8, E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; 9, 9Z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.</a:t>
            </a:r>
            <a:endParaRPr lang="ko-KR" altLang="ko-KR" sz="1200" kern="100" dirty="0">
              <a:effectLst/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 algn="just" latinLnBrk="1">
              <a:lnSpc>
                <a:spcPct val="100000"/>
              </a:lnSpc>
              <a:buFont typeface="+mj-lt"/>
              <a:buAutoNum type="arabicPeriod"/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3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C-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qMS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total ion chromatogram (TIC) chromatogram of seed (A) and leaf (B). 1. C20-ol; 2. C22-ol; 3. C24-ol; 4. δ-Tocopherol; 5. 5α-Cholestane; 6. C26-ol; 7. β-Tocopherol; 8. γ-Tocopherol; 9. C27-ol; 10. C28-ol; 11. α-Tocopherol; 12. Cholesterol; 13.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ampesterol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; 14. C30-ol; 15. Stigmasterol; 16. β-Sitosterol; 17. β-Amyrin; 18. α-Amyrin.</a:t>
            </a:r>
          </a:p>
          <a:p>
            <a:pPr algn="just" latinLnBrk="1">
              <a:lnSpc>
                <a:spcPct val="100000"/>
              </a:lnSpc>
              <a:buFont typeface="+mj-lt"/>
              <a:buAutoNum type="arabicPeriod"/>
            </a:pPr>
            <a:r>
              <a:rPr kumimoji="0" lang="en-US" altLang="ko-KR" sz="1200" b="1" i="0" u="none" strike="noStrike" kern="1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4. </a:t>
            </a:r>
            <a:r>
              <a:rPr lang="en-US" altLang="ko-KR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plots of PCA of metabolites extracted from BCE, Hybrid, and Wild leaves at 8 weeks (A), 12 weeks (B), and 16 weeks (C). Circles and triangles in the biplot represent samples and metabolites, respectively.</a:t>
            </a:r>
            <a:endParaRPr lang="ko-KR" altLang="ko-KR" sz="1200" kern="100" dirty="0">
              <a:solidFill>
                <a:srgbClr val="FF0000"/>
              </a:solidFill>
              <a:effectLst/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  <a:p>
            <a:pPr>
              <a:buFont typeface="+mj-lt"/>
              <a:buAutoNum type="arabicPeriod"/>
            </a:pP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C413AB3-7CAC-49AF-A457-CB48059AD047}"/>
              </a:ext>
            </a:extLst>
          </p:cNvPr>
          <p:cNvSpPr txBox="1"/>
          <p:nvPr/>
        </p:nvSpPr>
        <p:spPr>
          <a:xfrm>
            <a:off x="316260" y="577528"/>
            <a:ext cx="9273479" cy="2346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5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rticle</a:t>
            </a:r>
            <a:br>
              <a:rPr lang="en-US" altLang="ko-KR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</a:br>
            <a:br>
              <a:rPr lang="en-US" altLang="ko-KR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</a:br>
            <a:r>
              <a:rPr lang="en-US" altLang="ko-KR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bolomic variability of different soybean genotypes: β-carotene-enhanced (</a:t>
            </a:r>
            <a:r>
              <a:rPr lang="en-US" altLang="ko-KR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cine max</a:t>
            </a:r>
            <a:r>
              <a:rPr lang="en-US" altLang="ko-KR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wild (</a:t>
            </a:r>
            <a:r>
              <a:rPr lang="en-US" altLang="ko-KR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cine soja</a:t>
            </a:r>
            <a:r>
              <a:rPr lang="en-US" altLang="ko-KR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nd hybrid (</a:t>
            </a:r>
            <a:r>
              <a:rPr lang="en-US" altLang="ko-KR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cine max</a:t>
            </a:r>
            <a:r>
              <a:rPr lang="en-US" altLang="ko-KR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× </a:t>
            </a:r>
            <a:r>
              <a:rPr lang="en-US" altLang="ko-KR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cine soja</a:t>
            </a:r>
            <a:r>
              <a:rPr lang="en-US" altLang="ko-KR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oybeans</a:t>
            </a:r>
            <a:br>
              <a:rPr lang="ko-KR" altLang="ko-KR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ko-KR" altLang="ko-KR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</a:b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ung Won Jung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†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oo-Yun Park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†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ung-Dug Oh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0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ejin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ang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ang Jae Suh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oon Ki Park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un-Hwa Ha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ang Un Park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, and Jae Kwang Kim</a:t>
            </a:r>
            <a:r>
              <a:rPr lang="en-US" altLang="ko-KR" sz="10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br>
              <a:rPr lang="ko-KR" altLang="ko-KR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 </a:t>
            </a:r>
            <a:br>
              <a:rPr lang="en-US" altLang="ko-KR" sz="1100" dirty="0">
                <a:latin typeface="Palatino Linotype" panose="02040502050505030304" pitchFamily="18" charset="0"/>
                <a:cs typeface="Times New Roman" panose="02020603050405020304" pitchFamily="18" charset="0"/>
              </a:rPr>
            </a:br>
            <a:r>
              <a:rPr lang="en-US" altLang="ko-KR" sz="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vision of Life Sciences, Incheon National University, Incheon, 22012, Republic of Korea; 19961015@inu.ac.kr</a:t>
            </a:r>
            <a:br>
              <a:rPr lang="ko-KR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ional Institute of </a:t>
            </a:r>
            <a:r>
              <a:rPr lang="en-US" altLang="ko-KR" sz="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ricultural Sciences, Rural Development Administration (RDA), </a:t>
            </a:r>
            <a:r>
              <a:rPr lang="en-US" altLang="ko-KR" sz="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nju</a:t>
            </a:r>
            <a:r>
              <a:rPr lang="en-US" altLang="ko-KR" sz="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un, 55365, Republic of Korea; psy22@korea.kr (S.-Y.P.); ohbaboh@korea.kr (S.-D.O.); </a:t>
            </a:r>
            <a:r>
              <a:rPr lang="en-US" altLang="ko-KR" sz="8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jyejin@korea.k</a:t>
            </a:r>
            <a:r>
              <a:rPr lang="en-US" altLang="ko-KR" sz="800" dirty="0">
                <a:effectLst/>
                <a:latin typeface="Palatino Linotype" panose="02040502050505030304" pitchFamily="18" charset="0"/>
                <a:cs typeface="맑은 고딕" panose="020B0503020000020004" pitchFamily="50" charset="-127"/>
              </a:rPr>
              <a:t>r</a:t>
            </a:r>
            <a:r>
              <a:rPr lang="en-US" altLang="ko-KR" sz="8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ko-KR" sz="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Y.J.)</a:t>
            </a:r>
            <a:br>
              <a:rPr lang="ko-KR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hool of Applied Biosciences, Kyungpook National University, Daegu, 41566, Republic of Korea; sjsuh@knu.ac.kr (S.J.S); psk@knu.ac.kr (S.K.P)</a:t>
            </a:r>
            <a:br>
              <a:rPr lang="ko-KR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Genetic Engineering and Graduate School of Biotechnology, Kyung </a:t>
            </a:r>
            <a:r>
              <a:rPr lang="en-US" altLang="ko-KR" sz="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e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University, </a:t>
            </a:r>
            <a:r>
              <a:rPr lang="en-US" altLang="ko-KR" sz="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ongin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7104, Republic of Korea; sunhwa@khu.ac.kr</a:t>
            </a:r>
            <a:br>
              <a:rPr lang="ko-KR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Crop Science and Department of Smart Agriculture Systems, </a:t>
            </a:r>
            <a:r>
              <a:rPr lang="en-US" altLang="ko-KR" sz="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ungnam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ational University, 99 </a:t>
            </a:r>
            <a:r>
              <a:rPr lang="en-US" altLang="ko-KR" sz="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ehak-ro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useong-gu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Daejeon, 34134, Republic of Korea; </a:t>
            </a:r>
            <a:br>
              <a:rPr lang="ko-KR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rrespondence: supark@cnu.ac.kr (S.U.P.); kjkpj@inu.ac.kr (J.K.K.); Tel.: +82-42-821-5730 (S.U.P.); +82-32-835-8241 (J.K.K.)</a:t>
            </a:r>
            <a:br>
              <a:rPr lang="ko-KR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 </a:t>
            </a:r>
            <a:r>
              <a:rPr lang="en-US" altLang="ko-KR" sz="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se authors contributed equally to this work.</a:t>
            </a:r>
            <a:endParaRPr lang="ko-KR" altLang="en-US" sz="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529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A30E078C-7378-4328-A8F1-6F54543BFDA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538"/>
          <a:stretch/>
        </p:blipFill>
        <p:spPr>
          <a:xfrm>
            <a:off x="247650" y="542925"/>
            <a:ext cx="9658350" cy="378369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1EE89C4-8210-43CF-92C8-A71A60188C83}"/>
              </a:ext>
            </a:extLst>
          </p:cNvPr>
          <p:cNvSpPr txBox="1"/>
          <p:nvPr/>
        </p:nvSpPr>
        <p:spPr>
          <a:xfrm>
            <a:off x="0" y="542925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부제목 2">
            <a:extLst>
              <a:ext uri="{FF2B5EF4-FFF2-40B4-BE49-F238E27FC236}">
                <a16:creationId xmlns:a16="http://schemas.microsoft.com/office/drawing/2014/main" id="{EF605B1E-46CB-4CDB-A271-95257C4FABF8}"/>
              </a:ext>
            </a:extLst>
          </p:cNvPr>
          <p:cNvSpPr txBox="1">
            <a:spLocks/>
          </p:cNvSpPr>
          <p:nvPr/>
        </p:nvSpPr>
        <p:spPr>
          <a:xfrm>
            <a:off x="0" y="4744774"/>
            <a:ext cx="9906000" cy="13749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 latinLnBrk="1">
              <a:lnSpc>
                <a:spcPct val="100000"/>
              </a:lnSpc>
              <a:buNone/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1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C-TOF-MS analytical ion chromatogram (AIC) of hydrophilic compounds extracted from BCE seed (A) and leaf (B). 1, Pyruvic acid; 2, Lactic acid; 3, Alanine; 4, Oxalic acid; 5, Valine; 6, Urea; 7, Serine-1; 8, Glycerol; 9, Ethanolamine; 10, Leucine; 11, Phosphoric acid; 12, Isoleucine; 13, Proline; 14, Succinic acid; 15, Glycine; 16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lycer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17, Fumaric acid; 18, Serine-2; 19, Threonine; 20, β-Alanine; 21, Malic acid ; 22, Aspartic acid; 23, Methionine; 24, γ-Aminobutyric acid; 25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hreon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26, Glutamic acid; 27, Phenylalanine; 28, Xylose; 29, Arabinose; 30, Asparagine; 31, Xylitol; 32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Ribitol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; 33, Glutamine; 34, Shikimic acid; 35, Citric acid; 36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Quin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37, Fructose-1; 38, Fructose-2; 39, Mannose; 40, Galactose-1; 41, Glucose-1; 42, Lysine; 43, Ferulic acid; 44, Glucose-2; 45, Mannitol; 46, p-Coumaric acid; 47,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inapinic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acid; 48, Inositol; 49, Tryptophane; 50, Sucrose; 51, Raffinose; 52, Stachyose.</a:t>
            </a:r>
            <a:endParaRPr lang="ko-KR" altLang="ko-KR" sz="10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02501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부제목 2">
            <a:extLst>
              <a:ext uri="{FF2B5EF4-FFF2-40B4-BE49-F238E27FC236}">
                <a16:creationId xmlns:a16="http://schemas.microsoft.com/office/drawing/2014/main" id="{1420A141-ABCA-4C93-931B-9EC8469BEDDA}"/>
              </a:ext>
            </a:extLst>
          </p:cNvPr>
          <p:cNvSpPr txBox="1">
            <a:spLocks/>
          </p:cNvSpPr>
          <p:nvPr/>
        </p:nvSpPr>
        <p:spPr>
          <a:xfrm>
            <a:off x="0" y="4744774"/>
            <a:ext cx="9906000" cy="13749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buNone/>
            </a:pPr>
            <a:r>
              <a:rPr lang="en-US" altLang="ko-KR" sz="1200" b="1" dirty="0">
                <a:latin typeface="Times New Roman" panose="02020603050405020304" pitchFamily="18" charset="0"/>
                <a:ea typeface="Microsoft YaHei Light" panose="020B0502040204020203" pitchFamily="34" charset="-122"/>
                <a:cs typeface="Times New Roman" panose="02020603050405020304" pitchFamily="18" charset="0"/>
              </a:rPr>
              <a:t>Figure S1. </a:t>
            </a:r>
            <a:r>
              <a:rPr lang="en-US" altLang="ko-KR" sz="1200" i="1" dirty="0">
                <a:latin typeface="Times New Roman" panose="02020603050405020304" pitchFamily="18" charset="0"/>
                <a:ea typeface="Microsoft YaHei Light" panose="020B0502040204020203" pitchFamily="34" charset="-122"/>
                <a:cs typeface="Times New Roman" panose="02020603050405020304" pitchFamily="18" charset="0"/>
              </a:rPr>
              <a:t>(Continued)</a:t>
            </a:r>
            <a:endParaRPr lang="en-US" sz="1200" i="1" dirty="0">
              <a:latin typeface="Times New Roman" panose="02020603050405020304" pitchFamily="18" charset="0"/>
              <a:ea typeface="Microsoft YaHei Light" panose="020B0502040204020203" pitchFamily="34" charset="-122"/>
              <a:cs typeface="Times New Roman" panose="02020603050405020304" pitchFamily="18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99B7184-BD96-4517-83A3-2F73BF6D85D4}"/>
              </a:ext>
            </a:extLst>
          </p:cNvPr>
          <p:cNvSpPr txBox="1"/>
          <p:nvPr/>
        </p:nvSpPr>
        <p:spPr>
          <a:xfrm>
            <a:off x="0" y="558306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그림 76">
            <a:extLst>
              <a:ext uri="{FF2B5EF4-FFF2-40B4-BE49-F238E27FC236}">
                <a16:creationId xmlns:a16="http://schemas.microsoft.com/office/drawing/2014/main" id="{8B00444D-C3A1-40E8-A535-F45861129A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1" b="5558"/>
          <a:stretch/>
        </p:blipFill>
        <p:spPr>
          <a:xfrm>
            <a:off x="352425" y="558306"/>
            <a:ext cx="9530048" cy="37597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437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F757B8CD-AD44-4785-AD20-CC675359F7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325" y="3442658"/>
            <a:ext cx="9468000" cy="29674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F3B6EBE-286A-4297-9B07-A5283C62AF9F}"/>
              </a:ext>
            </a:extLst>
          </p:cNvPr>
          <p:cNvSpPr txBox="1"/>
          <p:nvPr/>
        </p:nvSpPr>
        <p:spPr>
          <a:xfrm>
            <a:off x="0" y="6396335"/>
            <a:ext cx="9906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0000"/>
              </a:lnSpc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2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HPLC chromatogram of carotenoid compounds from seed (A) and leaf (B). Peak: 1, Violaxanthin; 2, Lutein; 3, Zeaxanthin; 4, trans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Apo-8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al (IS); 5, 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ryptoxanthin; 6, 13Z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; 7, 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α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; 8, E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; 9, 9Z-</a:t>
            </a:r>
            <a:r>
              <a:rPr lang="ko-KR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-Carotene.</a:t>
            </a:r>
            <a:endParaRPr lang="ko-KR" altLang="ko-KR" sz="10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2D7C73F-4613-4032-89B6-6A1A3C2C5FB3}"/>
              </a:ext>
            </a:extLst>
          </p:cNvPr>
          <p:cNvSpPr txBox="1"/>
          <p:nvPr/>
        </p:nvSpPr>
        <p:spPr>
          <a:xfrm>
            <a:off x="0" y="3460983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972A4AE8-FC71-4F06-9C77-0A2D6C40D0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1324" y="59073"/>
            <a:ext cx="9434229" cy="3196556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8C7DE686-3C6F-4842-8778-32FAEEE0978D}"/>
              </a:ext>
            </a:extLst>
          </p:cNvPr>
          <p:cNvSpPr txBox="1"/>
          <p:nvPr/>
        </p:nvSpPr>
        <p:spPr>
          <a:xfrm>
            <a:off x="0" y="30498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06233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76CEDDEA-24D0-4A4D-88B7-16D2655763BC}"/>
              </a:ext>
            </a:extLst>
          </p:cNvPr>
          <p:cNvGrpSpPr/>
          <p:nvPr/>
        </p:nvGrpSpPr>
        <p:grpSpPr>
          <a:xfrm>
            <a:off x="342902" y="166683"/>
            <a:ext cx="9880256" cy="3086100"/>
            <a:chOff x="-1588" y="344488"/>
            <a:chExt cx="9148763" cy="3086100"/>
          </a:xfrm>
        </p:grpSpPr>
        <p:pic>
          <p:nvPicPr>
            <p:cNvPr id="3" name="Picture 10">
              <a:extLst>
                <a:ext uri="{FF2B5EF4-FFF2-40B4-BE49-F238E27FC236}">
                  <a16:creationId xmlns:a16="http://schemas.microsoft.com/office/drawing/2014/main" id="{1A3FD842-5063-445E-BD15-68CDC10B9E1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588" y="344488"/>
              <a:ext cx="9148763" cy="30861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31ECF90-251F-4FD3-A510-DAB62DD40388}"/>
                </a:ext>
              </a:extLst>
            </p:cNvPr>
            <p:cNvSpPr txBox="1"/>
            <p:nvPr/>
          </p:nvSpPr>
          <p:spPr>
            <a:xfrm>
              <a:off x="504069" y="2799646"/>
              <a:ext cx="24140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</a:t>
              </a:r>
              <a:endParaRPr lang="ko-KR" altLang="en-US" sz="105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717AECE-9C4A-4748-9743-3F1A57C76F6B}"/>
                </a:ext>
              </a:extLst>
            </p:cNvPr>
            <p:cNvSpPr txBox="1"/>
            <p:nvPr/>
          </p:nvSpPr>
          <p:spPr>
            <a:xfrm>
              <a:off x="1870617" y="2780928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2</a:t>
              </a:r>
              <a:endParaRPr lang="ko-KR" altLang="en-US" sz="1050" dirty="0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8A97C23-2C1A-49E7-91D1-58B24CF1F522}"/>
                </a:ext>
              </a:extLst>
            </p:cNvPr>
            <p:cNvSpPr txBox="1"/>
            <p:nvPr/>
          </p:nvSpPr>
          <p:spPr>
            <a:xfrm>
              <a:off x="3166760" y="2735342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3</a:t>
              </a:r>
              <a:endParaRPr lang="ko-KR" altLang="en-US" sz="105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F0736B8-FDD4-4694-933E-7D6D61554311}"/>
                </a:ext>
              </a:extLst>
            </p:cNvPr>
            <p:cNvSpPr txBox="1"/>
            <p:nvPr/>
          </p:nvSpPr>
          <p:spPr>
            <a:xfrm>
              <a:off x="4222925" y="1406068"/>
              <a:ext cx="3390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4,5</a:t>
              </a:r>
              <a:endParaRPr lang="ko-KR" altLang="en-US" sz="105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9BFB60F-3448-482A-9B20-2A1C2CB162FF}"/>
                </a:ext>
              </a:extLst>
            </p:cNvPr>
            <p:cNvSpPr txBox="1"/>
            <p:nvPr/>
          </p:nvSpPr>
          <p:spPr>
            <a:xfrm>
              <a:off x="4364475" y="2636912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6</a:t>
              </a:r>
              <a:endParaRPr lang="ko-KR" altLang="en-US" sz="105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07760D5-408E-4227-BE1B-EA712D9CFAC5}"/>
                </a:ext>
              </a:extLst>
            </p:cNvPr>
            <p:cNvSpPr txBox="1"/>
            <p:nvPr/>
          </p:nvSpPr>
          <p:spPr>
            <a:xfrm>
              <a:off x="4822945" y="2538036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7</a:t>
              </a:r>
              <a:endParaRPr lang="ko-KR" altLang="en-US" sz="105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08A5B4A-59EC-438C-90E9-9FAA9CE3DC57}"/>
                </a:ext>
              </a:extLst>
            </p:cNvPr>
            <p:cNvSpPr txBox="1"/>
            <p:nvPr/>
          </p:nvSpPr>
          <p:spPr>
            <a:xfrm>
              <a:off x="4868531" y="476672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8</a:t>
              </a:r>
              <a:endParaRPr lang="ko-KR" altLang="en-US" sz="105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4627D94-BEE4-4ECB-99B0-37A584DD8BB7}"/>
                </a:ext>
              </a:extLst>
            </p:cNvPr>
            <p:cNvSpPr txBox="1"/>
            <p:nvPr/>
          </p:nvSpPr>
          <p:spPr>
            <a:xfrm>
              <a:off x="5542151" y="2519318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0</a:t>
              </a:r>
              <a:endParaRPr lang="ko-KR" altLang="en-US" sz="105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D106D89-B20F-422C-A06F-356A606FABCD}"/>
                </a:ext>
              </a:extLst>
            </p:cNvPr>
            <p:cNvSpPr txBox="1"/>
            <p:nvPr/>
          </p:nvSpPr>
          <p:spPr>
            <a:xfrm>
              <a:off x="5880705" y="2276426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1</a:t>
              </a:r>
              <a:endParaRPr lang="ko-KR" altLang="en-US" sz="105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7F83757-72AF-4531-A975-4130C09F12E5}"/>
                </a:ext>
              </a:extLst>
            </p:cNvPr>
            <p:cNvSpPr txBox="1"/>
            <p:nvPr/>
          </p:nvSpPr>
          <p:spPr>
            <a:xfrm>
              <a:off x="6118215" y="2447310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2</a:t>
              </a:r>
              <a:endParaRPr lang="ko-KR" altLang="en-US" sz="105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06BC161-7468-418C-AFF0-51BF8764F1C1}"/>
                </a:ext>
              </a:extLst>
            </p:cNvPr>
            <p:cNvSpPr txBox="1"/>
            <p:nvPr/>
          </p:nvSpPr>
          <p:spPr>
            <a:xfrm>
              <a:off x="6988722" y="791126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3</a:t>
              </a:r>
              <a:endParaRPr lang="ko-KR" altLang="en-US" sz="105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8D716C6-BC80-4588-A9D5-8973AE642D7E}"/>
                </a:ext>
              </a:extLst>
            </p:cNvPr>
            <p:cNvSpPr txBox="1"/>
            <p:nvPr/>
          </p:nvSpPr>
          <p:spPr>
            <a:xfrm>
              <a:off x="8140851" y="2382996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7</a:t>
              </a:r>
              <a:endParaRPr lang="ko-KR" altLang="en-US" sz="105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4644B77-A343-4B4B-80D5-6C1A40CF4342}"/>
                </a:ext>
              </a:extLst>
            </p:cNvPr>
            <p:cNvSpPr txBox="1"/>
            <p:nvPr/>
          </p:nvSpPr>
          <p:spPr>
            <a:xfrm>
              <a:off x="7680904" y="491897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6</a:t>
              </a:r>
              <a:endParaRPr lang="ko-KR" altLang="en-US" sz="105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A780FCD-1808-483F-AB0F-1145DC483626}"/>
                </a:ext>
              </a:extLst>
            </p:cNvPr>
            <p:cNvSpPr txBox="1"/>
            <p:nvPr/>
          </p:nvSpPr>
          <p:spPr>
            <a:xfrm>
              <a:off x="7248857" y="1764427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5</a:t>
              </a:r>
              <a:endParaRPr lang="ko-KR" altLang="en-US" sz="1050" dirty="0"/>
            </a:p>
          </p:txBody>
        </p:sp>
      </p:grpSp>
      <p:grpSp>
        <p:nvGrpSpPr>
          <p:cNvPr id="19" name="그룹 18">
            <a:extLst>
              <a:ext uri="{FF2B5EF4-FFF2-40B4-BE49-F238E27FC236}">
                <a16:creationId xmlns:a16="http://schemas.microsoft.com/office/drawing/2014/main" id="{F30B5E63-B3AC-4C57-B9A2-928EFCB9CAA8}"/>
              </a:ext>
            </a:extLst>
          </p:cNvPr>
          <p:cNvGrpSpPr/>
          <p:nvPr/>
        </p:nvGrpSpPr>
        <p:grpSpPr>
          <a:xfrm>
            <a:off x="342901" y="3332311"/>
            <a:ext cx="9880256" cy="3035300"/>
            <a:chOff x="-1588" y="764704"/>
            <a:chExt cx="9148763" cy="3035300"/>
          </a:xfrm>
        </p:grpSpPr>
        <p:pic>
          <p:nvPicPr>
            <p:cNvPr id="20" name="Picture 4">
              <a:extLst>
                <a:ext uri="{FF2B5EF4-FFF2-40B4-BE49-F238E27FC236}">
                  <a16:creationId xmlns:a16="http://schemas.microsoft.com/office/drawing/2014/main" id="{97D41AAE-91F8-4DFD-8BB7-2E180CBD295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588" y="764704"/>
              <a:ext cx="9148763" cy="3035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2DB7E56-219A-48C2-9E97-85ED5C40CBDD}"/>
                </a:ext>
              </a:extLst>
            </p:cNvPr>
            <p:cNvSpPr txBox="1"/>
            <p:nvPr/>
          </p:nvSpPr>
          <p:spPr>
            <a:xfrm>
              <a:off x="333631" y="3095382"/>
              <a:ext cx="24140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</a:t>
              </a:r>
              <a:endParaRPr lang="ko-KR" altLang="en-US" sz="105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80D0333-B046-4322-A54F-EA2273E8466D}"/>
                </a:ext>
              </a:extLst>
            </p:cNvPr>
            <p:cNvSpPr txBox="1"/>
            <p:nvPr/>
          </p:nvSpPr>
          <p:spPr>
            <a:xfrm>
              <a:off x="1700178" y="3076664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2</a:t>
              </a:r>
              <a:endParaRPr lang="ko-KR" altLang="en-US" sz="105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F15D00D-A64B-4192-A82C-7D7F6355E4EB}"/>
                </a:ext>
              </a:extLst>
            </p:cNvPr>
            <p:cNvSpPr txBox="1"/>
            <p:nvPr/>
          </p:nvSpPr>
          <p:spPr>
            <a:xfrm>
              <a:off x="2946022" y="3033640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3</a:t>
              </a:r>
              <a:endParaRPr lang="ko-KR" altLang="en-US" sz="105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44F6B19-39FB-471F-A4F6-51E876384ED3}"/>
                </a:ext>
              </a:extLst>
            </p:cNvPr>
            <p:cNvSpPr txBox="1"/>
            <p:nvPr/>
          </p:nvSpPr>
          <p:spPr>
            <a:xfrm>
              <a:off x="4034063" y="2815044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4</a:t>
              </a:r>
              <a:endParaRPr lang="ko-KR" altLang="en-US" sz="105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BEBE95F-7FBB-424A-8CA8-B6B9224B3C45}"/>
                </a:ext>
              </a:extLst>
            </p:cNvPr>
            <p:cNvSpPr txBox="1"/>
            <p:nvPr/>
          </p:nvSpPr>
          <p:spPr>
            <a:xfrm>
              <a:off x="4104469" y="3023374"/>
              <a:ext cx="24140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5</a:t>
              </a:r>
              <a:endParaRPr lang="ko-KR" altLang="en-US" sz="105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1F56C82-1FAB-4ACB-AAB7-6975368D9D76}"/>
                </a:ext>
              </a:extLst>
            </p:cNvPr>
            <p:cNvSpPr txBox="1"/>
            <p:nvPr/>
          </p:nvSpPr>
          <p:spPr>
            <a:xfrm>
              <a:off x="4534913" y="2924944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7</a:t>
              </a:r>
              <a:endParaRPr lang="ko-KR" altLang="en-US" sz="105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3BAB893-27B5-457F-BADD-42D0AEB48DFA}"/>
                </a:ext>
              </a:extLst>
            </p:cNvPr>
            <p:cNvSpPr txBox="1"/>
            <p:nvPr/>
          </p:nvSpPr>
          <p:spPr>
            <a:xfrm>
              <a:off x="4601985" y="2879358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8</a:t>
              </a:r>
              <a:endParaRPr lang="ko-KR" altLang="en-US" sz="105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677A872-7C46-4CD6-9761-FE98AAABB222}"/>
                </a:ext>
              </a:extLst>
            </p:cNvPr>
            <p:cNvSpPr txBox="1"/>
            <p:nvPr/>
          </p:nvSpPr>
          <p:spPr>
            <a:xfrm>
              <a:off x="4673993" y="3055749"/>
              <a:ext cx="2414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9</a:t>
              </a:r>
              <a:endParaRPr lang="ko-KR" altLang="en-US" sz="105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F4384DC-CF45-4FCD-813A-1F77F4702234}"/>
                </a:ext>
              </a:extLst>
            </p:cNvPr>
            <p:cNvSpPr txBox="1"/>
            <p:nvPr/>
          </p:nvSpPr>
          <p:spPr>
            <a:xfrm>
              <a:off x="5254119" y="2519318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0</a:t>
              </a:r>
              <a:endParaRPr lang="ko-KR" altLang="en-US" sz="105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68CBA70-B26C-4715-A683-0DDE721269B0}"/>
                </a:ext>
              </a:extLst>
            </p:cNvPr>
            <p:cNvSpPr txBox="1"/>
            <p:nvPr/>
          </p:nvSpPr>
          <p:spPr>
            <a:xfrm>
              <a:off x="5448656" y="863134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1</a:t>
              </a:r>
              <a:endParaRPr lang="ko-KR" altLang="en-US" sz="105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2E75444-9F68-418E-9FEB-C9EC584861F3}"/>
                </a:ext>
              </a:extLst>
            </p:cNvPr>
            <p:cNvSpPr txBox="1"/>
            <p:nvPr/>
          </p:nvSpPr>
          <p:spPr>
            <a:xfrm>
              <a:off x="8112953" y="1052736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8</a:t>
              </a:r>
              <a:endParaRPr lang="ko-KR" altLang="en-US" sz="105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CC1586D-76FF-458F-AFA5-926724875179}"/>
                </a:ext>
              </a:extLst>
            </p:cNvPr>
            <p:cNvSpPr txBox="1"/>
            <p:nvPr/>
          </p:nvSpPr>
          <p:spPr>
            <a:xfrm>
              <a:off x="6622271" y="2375302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2</a:t>
              </a:r>
              <a:endParaRPr lang="ko-KR" altLang="en-US" sz="105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BBEF7DD-69ED-4DA6-9216-CD7F78395300}"/>
                </a:ext>
              </a:extLst>
            </p:cNvPr>
            <p:cNvSpPr txBox="1"/>
            <p:nvPr/>
          </p:nvSpPr>
          <p:spPr>
            <a:xfrm>
              <a:off x="6744801" y="2564904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3</a:t>
              </a:r>
              <a:endParaRPr lang="ko-KR" altLang="en-US" sz="1050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12C0779-C537-4953-99E5-C1D79601A396}"/>
                </a:ext>
              </a:extLst>
            </p:cNvPr>
            <p:cNvSpPr txBox="1"/>
            <p:nvPr/>
          </p:nvSpPr>
          <p:spPr>
            <a:xfrm>
              <a:off x="7752913" y="1363638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7</a:t>
              </a:r>
              <a:endParaRPr lang="ko-KR" altLang="en-US" sz="105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128121E-ED3C-462A-AD55-1C1D9B645BD9}"/>
                </a:ext>
              </a:extLst>
            </p:cNvPr>
            <p:cNvSpPr txBox="1"/>
            <p:nvPr/>
          </p:nvSpPr>
          <p:spPr>
            <a:xfrm>
              <a:off x="7320865" y="836712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5</a:t>
              </a:r>
              <a:endParaRPr lang="ko-KR" altLang="en-US" sz="105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01345C2-0A43-413A-8E83-37D8DB0AE7C8}"/>
                </a:ext>
              </a:extLst>
            </p:cNvPr>
            <p:cNvSpPr txBox="1"/>
            <p:nvPr/>
          </p:nvSpPr>
          <p:spPr>
            <a:xfrm>
              <a:off x="6888817" y="1518900"/>
              <a:ext cx="3070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14</a:t>
              </a:r>
              <a:endParaRPr lang="ko-KR" altLang="en-US" sz="1050" dirty="0"/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7B8B1739-A860-419E-A913-520292C33658}"/>
              </a:ext>
            </a:extLst>
          </p:cNvPr>
          <p:cNvSpPr txBox="1"/>
          <p:nvPr/>
        </p:nvSpPr>
        <p:spPr>
          <a:xfrm>
            <a:off x="37434" y="3377388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B3CFDC0-6216-459C-8FAF-C09328C2F3CC}"/>
              </a:ext>
            </a:extLst>
          </p:cNvPr>
          <p:cNvSpPr txBox="1"/>
          <p:nvPr/>
        </p:nvSpPr>
        <p:spPr>
          <a:xfrm>
            <a:off x="37434" y="245006"/>
            <a:ext cx="787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부제목 2">
            <a:extLst>
              <a:ext uri="{FF2B5EF4-FFF2-40B4-BE49-F238E27FC236}">
                <a16:creationId xmlns:a16="http://schemas.microsoft.com/office/drawing/2014/main" id="{3E2C92B3-62A8-4DFA-B285-1EE8B69B1F03}"/>
              </a:ext>
            </a:extLst>
          </p:cNvPr>
          <p:cNvSpPr txBox="1">
            <a:spLocks/>
          </p:cNvSpPr>
          <p:nvPr/>
        </p:nvSpPr>
        <p:spPr>
          <a:xfrm>
            <a:off x="180975" y="6180062"/>
            <a:ext cx="9382125" cy="6923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 latinLnBrk="1">
              <a:lnSpc>
                <a:spcPct val="100000"/>
              </a:lnSpc>
              <a:buNone/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3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C-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qMS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total ion chromatogram (TIC) chromatogram of seed (A) and leaf (B). 1. C20-ol; 2. C22-ol; 3. C24-ol; 4. δ-Tocopherol; 5. 5α-Cholestane; 6. C26-ol; 7. β-Tocopherol; 8. γ-Tocopherol; 9. C27-ol; 10. C28-ol; 11. α-Tocopherol; 12. Cholesterol; 13. </a:t>
            </a:r>
            <a:r>
              <a:rPr lang="en-US" altLang="ko-KR" sz="1200" kern="100" dirty="0" err="1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Campesterol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; 14. C30-ol; 15. Stigmasterol; 16. β-Sitosterol; 17. β-Amyrin; 18. α-Amyrin.</a:t>
            </a:r>
            <a:endParaRPr lang="ko-KR" altLang="ko-KR" sz="10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97160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D1DF021D-371D-4A65-8182-4F0EA872AD0B}"/>
              </a:ext>
            </a:extLst>
          </p:cNvPr>
          <p:cNvPicPr/>
          <p:nvPr/>
        </p:nvPicPr>
        <p:blipFill rotWithShape="1">
          <a:blip r:embed="rId2"/>
          <a:srcRect b="33061"/>
          <a:stretch/>
        </p:blipFill>
        <p:spPr>
          <a:xfrm>
            <a:off x="2087879" y="312662"/>
            <a:ext cx="5730240" cy="5524500"/>
          </a:xfrm>
          <a:prstGeom prst="rect">
            <a:avLst/>
          </a:prstGeom>
        </p:spPr>
      </p:pic>
      <p:sp>
        <p:nvSpPr>
          <p:cNvPr id="3" name="부제목 2">
            <a:extLst>
              <a:ext uri="{FF2B5EF4-FFF2-40B4-BE49-F238E27FC236}">
                <a16:creationId xmlns:a16="http://schemas.microsoft.com/office/drawing/2014/main" id="{03593DD6-F5F2-41AC-9447-7927DFD64D8B}"/>
              </a:ext>
            </a:extLst>
          </p:cNvPr>
          <p:cNvSpPr txBox="1">
            <a:spLocks/>
          </p:cNvSpPr>
          <p:nvPr/>
        </p:nvSpPr>
        <p:spPr>
          <a:xfrm>
            <a:off x="261937" y="6014962"/>
            <a:ext cx="9382125" cy="69232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 latinLnBrk="1">
              <a:lnSpc>
                <a:spcPct val="100000"/>
              </a:lnSpc>
              <a:buNone/>
            </a:pPr>
            <a:r>
              <a:rPr kumimoji="0" lang="en-US" altLang="ko-KR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ure S4. </a:t>
            </a:r>
            <a:r>
              <a:rPr lang="en-US" altLang="ko-K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iplots of PCA of metabolites extracted from BCE, Hybrid, and Wild leaves at 8 weeks (A), 12 weeks (B), and 16 weeks (C). Circles and triangles in the biplot represent samples and metabolites, respectively.</a:t>
            </a:r>
            <a:endParaRPr lang="ko-KR" altLang="ko-KR" sz="1200" kern="100" dirty="0">
              <a:effectLst/>
              <a:latin typeface="Times New Roman" panose="02020603050405020304" pitchFamily="18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28838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DF784B60-FF2D-412F-80A0-E7A274D07594}"/>
              </a:ext>
            </a:extLst>
          </p:cNvPr>
          <p:cNvPicPr/>
          <p:nvPr/>
        </p:nvPicPr>
        <p:blipFill rotWithShape="1">
          <a:blip r:embed="rId2"/>
          <a:srcRect t="66938"/>
          <a:stretch/>
        </p:blipFill>
        <p:spPr>
          <a:xfrm>
            <a:off x="1397000" y="254000"/>
            <a:ext cx="6769100" cy="4292600"/>
          </a:xfrm>
          <a:prstGeom prst="rect">
            <a:avLst/>
          </a:prstGeom>
        </p:spPr>
      </p:pic>
      <p:sp>
        <p:nvSpPr>
          <p:cNvPr id="3" name="부제목 2">
            <a:extLst>
              <a:ext uri="{FF2B5EF4-FFF2-40B4-BE49-F238E27FC236}">
                <a16:creationId xmlns:a16="http://schemas.microsoft.com/office/drawing/2014/main" id="{01F4642D-FB77-4939-9BC1-F4E5C3B5EA00}"/>
              </a:ext>
            </a:extLst>
          </p:cNvPr>
          <p:cNvSpPr txBox="1">
            <a:spLocks/>
          </p:cNvSpPr>
          <p:nvPr/>
        </p:nvSpPr>
        <p:spPr>
          <a:xfrm>
            <a:off x="0" y="4744774"/>
            <a:ext cx="9906000" cy="13749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buNone/>
            </a:pPr>
            <a:r>
              <a:rPr lang="en-US" altLang="ko-KR" sz="1200" b="1" dirty="0">
                <a:latin typeface="Times New Roman" panose="02020603050405020304" pitchFamily="18" charset="0"/>
                <a:ea typeface="Microsoft YaHei Light" panose="020B0502040204020203" pitchFamily="34" charset="-122"/>
                <a:cs typeface="Times New Roman" panose="02020603050405020304" pitchFamily="18" charset="0"/>
              </a:rPr>
              <a:t>Figure S4. </a:t>
            </a:r>
            <a:r>
              <a:rPr lang="en-US" altLang="ko-KR" sz="1200" i="1" dirty="0">
                <a:latin typeface="Times New Roman" panose="02020603050405020304" pitchFamily="18" charset="0"/>
                <a:ea typeface="Microsoft YaHei Light" panose="020B0502040204020203" pitchFamily="34" charset="-122"/>
                <a:cs typeface="Times New Roman" panose="02020603050405020304" pitchFamily="18" charset="0"/>
              </a:rPr>
              <a:t>(Continued)</a:t>
            </a:r>
            <a:endParaRPr lang="en-US" sz="1200" i="1" dirty="0">
              <a:latin typeface="Times New Roman" panose="02020603050405020304" pitchFamily="18" charset="0"/>
              <a:ea typeface="Microsoft YaHei Light" panose="020B0502040204020203" pitchFamily="34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5655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</TotalTime>
  <Words>1304</Words>
  <Application>Microsoft Office PowerPoint</Application>
  <PresentationFormat>A4 용지(210x297mm)</PresentationFormat>
  <Paragraphs>49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4" baseType="lpstr">
      <vt:lpstr>바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jin Hyeon</dc:creator>
  <cp:lastModifiedBy>Hyejin Hyeon</cp:lastModifiedBy>
  <cp:revision>11</cp:revision>
  <dcterms:created xsi:type="dcterms:W3CDTF">2021-06-16T09:12:51Z</dcterms:created>
  <dcterms:modified xsi:type="dcterms:W3CDTF">2021-09-23T12:17:59Z</dcterms:modified>
</cp:coreProperties>
</file>